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50" autoAdjust="0"/>
    <p:restoredTop sz="94660"/>
  </p:normalViewPr>
  <p:slideViewPr>
    <p:cSldViewPr snapToGrid="0" showGuides="1">
      <p:cViewPr>
        <p:scale>
          <a:sx n="180" d="100"/>
          <a:sy n="180" d="100"/>
        </p:scale>
        <p:origin x="-173" y="2698"/>
      </p:cViewPr>
      <p:guideLst>
        <p:guide orient="horz" pos="5759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\Desktop\Th&#232;se\Projet%20E2F1\Exp&#233;riences\Viabilit&#233;%20cellulaire\Inhibiteur%20E2F\A375\Viabilit&#233;%20A375%20Inhibiteur%20E2F%20cinetique%20et%20Si%20E2F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Exp&#233;riences\Souris%20E2F1--\Souris%20Nude%20A375%20S%20et%20R5C3%20LAbra%20+%20Inhib%20+%20PLX\Courbes%20tumeurs\Souris%20Nud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h&#232;se\Projet%20E2F1\Exp&#233;riences\Viabilit&#233;%20cellulaire\Inhibiteur%20E2F\Cellules%20normales\Viabilit&#233;%20KHN%20et%20MHN%204j%20Inhibiteur%20E2F%2020%20microM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Exp&#233;riences\Souris%20E2F1--\Souris%20Nude%20A375%20S%20et%20R5C3%20LAbra%20+%20Inhib%20+%20PLX\Courbes%20tumeurs\Souris%20Nude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lorian\Desktop\These%20Flo\Th&#232;se%20Bis\Projet%20E2F1\Exp&#233;riences\Viabilit&#233;%20cellulaire\Inhibiteur%20E2F\Viabilit&#233;%20A375%201205%20Lu%20SK%20MAG%20BER%20LAL%20Mewo%20Mel501%204j%20Inhibiteur%20E2F%20+%20Si%20E2F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edra\Documents\Nedra%20ordi%20labo\Postdoc\E2F1\qPCR\Analyse%20qPCR%2028-12-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>
        <c:manualLayout>
          <c:layoutTarget val="inner"/>
          <c:xMode val="edge"/>
          <c:yMode val="edge"/>
          <c:x val="8.8022521461754238E-2"/>
          <c:y val="2.8712345679012499E-2"/>
          <c:w val="0.91197747853824607"/>
          <c:h val="0.87223580246914922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F$52,Feuil1!$H$52,Feuil1!$J$52)</c:f>
                <c:numCache>
                  <c:formatCode>General</c:formatCode>
                  <c:ptCount val="3"/>
                  <c:pt idx="0">
                    <c:v>4.2253521126759805</c:v>
                  </c:pt>
                  <c:pt idx="1">
                    <c:v>2.988037319807781</c:v>
                  </c:pt>
                  <c:pt idx="2">
                    <c:v>3.72641029727436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Feuil1!$E$38:$G$38</c:f>
              <c:strCache>
                <c:ptCount val="3"/>
                <c:pt idx="0">
                  <c:v>Day 2 </c:v>
                </c:pt>
                <c:pt idx="1">
                  <c:v>Day 3</c:v>
                </c:pt>
                <c:pt idx="2">
                  <c:v>Day 4</c:v>
                </c:pt>
              </c:strCache>
            </c:strRef>
          </c:cat>
          <c:val>
            <c:numRef>
              <c:f>(Feuil1!$F$51,Feuil1!$H$51,Feuil1!$J$51)</c:f>
              <c:numCache>
                <c:formatCode>0.00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G$52,Feuil1!$I$52,Feuil1!$K$52)</c:f>
                <c:numCache>
                  <c:formatCode>General</c:formatCode>
                  <c:ptCount val="3"/>
                  <c:pt idx="0">
                    <c:v>5.3323083059155714</c:v>
                  </c:pt>
                  <c:pt idx="1">
                    <c:v>4.3062200956938623</c:v>
                  </c:pt>
                  <c:pt idx="2">
                    <c:v>4.30288797648432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Feuil1!$E$38:$G$38</c:f>
              <c:strCache>
                <c:ptCount val="3"/>
                <c:pt idx="0">
                  <c:v>Day 2 </c:v>
                </c:pt>
                <c:pt idx="1">
                  <c:v>Day 3</c:v>
                </c:pt>
                <c:pt idx="2">
                  <c:v>Day 4</c:v>
                </c:pt>
              </c:strCache>
            </c:strRef>
          </c:cat>
          <c:val>
            <c:numRef>
              <c:f>(Feuil1!$G$51,Feuil1!$I$51,Feuil1!$K$51)</c:f>
              <c:numCache>
                <c:formatCode>0.00</c:formatCode>
                <c:ptCount val="3"/>
                <c:pt idx="0">
                  <c:v>76.995305164319262</c:v>
                </c:pt>
                <c:pt idx="1">
                  <c:v>35.885167464114787</c:v>
                </c:pt>
                <c:pt idx="2">
                  <c:v>12.206572769953048</c:v>
                </c:pt>
              </c:numCache>
            </c:numRef>
          </c:val>
        </c:ser>
        <c:dLbls/>
        <c:axId val="108255872"/>
        <c:axId val="109072768"/>
      </c:barChart>
      <c:catAx>
        <c:axId val="108255872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9072768"/>
        <c:crosses val="autoZero"/>
        <c:auto val="1"/>
        <c:lblAlgn val="ctr"/>
        <c:lblOffset val="100"/>
      </c:catAx>
      <c:valAx>
        <c:axId val="109072768"/>
        <c:scaling>
          <c:orientation val="minMax"/>
          <c:max val="120"/>
        </c:scaling>
        <c:axPos val="l"/>
        <c:numFmt formatCode="0" sourceLinked="0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8255872"/>
        <c:crosses val="autoZero"/>
        <c:crossBetween val="between"/>
        <c:majorUnit val="20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lineChart>
        <c:grouping val="standard"/>
        <c:ser>
          <c:idx val="0"/>
          <c:order val="0"/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(Feuil1!$F$11;Feuil1!$H$11;Feuil1!$J$11;Feuil1!$L$11;Feuil1!$N$11;Feuil1!$P$11;Feuil1!$R$11;Feuil1!$T$11;Feuil1!$V$11;Feuil1!$X$11)</c:f>
                <c:numCache>
                  <c:formatCode>General</c:formatCode>
                  <c:ptCount val="10"/>
                  <c:pt idx="0">
                    <c:v>12.49677907530015</c:v>
                  </c:pt>
                  <c:pt idx="1">
                    <c:v>26.535523098219269</c:v>
                  </c:pt>
                  <c:pt idx="2">
                    <c:v>27.888438155595459</c:v>
                  </c:pt>
                  <c:pt idx="3">
                    <c:v>40.580070911989012</c:v>
                  </c:pt>
                  <c:pt idx="4">
                    <c:v>46.002800996406123</c:v>
                  </c:pt>
                  <c:pt idx="5">
                    <c:v>72.481900977243271</c:v>
                  </c:pt>
                  <c:pt idx="6">
                    <c:v>127.2031951333076</c:v>
                  </c:pt>
                  <c:pt idx="7">
                    <c:v>121.14235438545079</c:v>
                  </c:pt>
                  <c:pt idx="8">
                    <c:v>196.13974779175408</c:v>
                  </c:pt>
                  <c:pt idx="9">
                    <c:v>203.33000570863001</c:v>
                  </c:pt>
                </c:numCache>
              </c:numRef>
            </c:plus>
            <c:minus>
              <c:numRef>
                <c:f>(Feuil1!$F$11;Feuil1!$H$11;Feuil1!$J$11;Feuil1!$L$11;Feuil1!$N$11;Feuil1!$P$11;Feuil1!$R$11;Feuil1!$T$11;Feuil1!$V$11;Feuil1!$X$11)</c:f>
                <c:numCache>
                  <c:formatCode>General</c:formatCode>
                  <c:ptCount val="10"/>
                  <c:pt idx="0">
                    <c:v>12.49677907530015</c:v>
                  </c:pt>
                  <c:pt idx="1">
                    <c:v>26.535523098219269</c:v>
                  </c:pt>
                  <c:pt idx="2">
                    <c:v>27.888438155595459</c:v>
                  </c:pt>
                  <c:pt idx="3">
                    <c:v>40.580070911989012</c:v>
                  </c:pt>
                  <c:pt idx="4">
                    <c:v>46.002800996406123</c:v>
                  </c:pt>
                  <c:pt idx="5">
                    <c:v>72.481900977243271</c:v>
                  </c:pt>
                  <c:pt idx="6">
                    <c:v>127.2031951333076</c:v>
                  </c:pt>
                  <c:pt idx="7">
                    <c:v>121.14235438545079</c:v>
                  </c:pt>
                  <c:pt idx="8">
                    <c:v>196.13974779175408</c:v>
                  </c:pt>
                  <c:pt idx="9">
                    <c:v>203.33000570863001</c:v>
                  </c:pt>
                </c:numCache>
              </c:numRef>
            </c:minus>
          </c:errBars>
          <c:cat>
            <c:numRef>
              <c:f>(Feuil1!$F$3;Feuil1!$H$3;Feuil1!$J$3;Feuil1!$L$3;Feuil1!$N$3;Feuil1!$P$3;Feuil1!$R$3;Feuil1!$T$3;Feuil1!$V$3;Feuil1!$X$3)</c:f>
              <c:numCache>
                <c:formatCode>General</c:formatCode>
                <c:ptCount val="10"/>
                <c:pt idx="0">
                  <c:v>6</c:v>
                </c:pt>
                <c:pt idx="1">
                  <c:v>8</c:v>
                </c:pt>
                <c:pt idx="2">
                  <c:v>10</c:v>
                </c:pt>
                <c:pt idx="3">
                  <c:v>13</c:v>
                </c:pt>
                <c:pt idx="4">
                  <c:v>15</c:v>
                </c:pt>
                <c:pt idx="5">
                  <c:v>17</c:v>
                </c:pt>
                <c:pt idx="6">
                  <c:v>22</c:v>
                </c:pt>
                <c:pt idx="7">
                  <c:v>24</c:v>
                </c:pt>
                <c:pt idx="8">
                  <c:v>26</c:v>
                </c:pt>
                <c:pt idx="9">
                  <c:v>29</c:v>
                </c:pt>
              </c:numCache>
            </c:numRef>
          </c:cat>
          <c:val>
            <c:numRef>
              <c:f>(Feuil1!$F$10;Feuil1!$H$10;Feuil1!$J$10;Feuil1!$L$10;Feuil1!$N$10;Feuil1!$P$10;Feuil1!$R$10;Feuil1!$T$10;Feuil1!$V$10;Feuil1!$X$10)</c:f>
              <c:numCache>
                <c:formatCode>General</c:formatCode>
                <c:ptCount val="10"/>
                <c:pt idx="0">
                  <c:v>72.450348381428469</c:v>
                </c:pt>
                <c:pt idx="1">
                  <c:v>121.49097114166659</c:v>
                </c:pt>
                <c:pt idx="2">
                  <c:v>153.57684589466658</c:v>
                </c:pt>
                <c:pt idx="3">
                  <c:v>224.05753337900001</c:v>
                </c:pt>
                <c:pt idx="4">
                  <c:v>256.05979230444473</c:v>
                </c:pt>
                <c:pt idx="5">
                  <c:v>324.76754376933332</c:v>
                </c:pt>
                <c:pt idx="6">
                  <c:v>686.77174952566816</c:v>
                </c:pt>
                <c:pt idx="7">
                  <c:v>900.26176917199996</c:v>
                </c:pt>
                <c:pt idx="8">
                  <c:v>1342.5906073670001</c:v>
                </c:pt>
                <c:pt idx="9">
                  <c:v>1581.1520915099998</c:v>
                </c:pt>
              </c:numCache>
            </c:numRef>
          </c:val>
        </c:ser>
        <c:ser>
          <c:idx val="1"/>
          <c:order val="1"/>
          <c:spPr>
            <a:ln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(Feuil1!$F$27;Feuil1!$H$27;Feuil1!$J$27;Feuil1!$L$27;Feuil1!$N$27;Feuil1!$P$27;Feuil1!$R$27;Feuil1!$T$27;Feuil1!$V$27;Feuil1!$X$27)</c:f>
                <c:numCache>
                  <c:formatCode>General</c:formatCode>
                  <c:ptCount val="10"/>
                  <c:pt idx="0">
                    <c:v>4.4419050231181973</c:v>
                  </c:pt>
                  <c:pt idx="1">
                    <c:v>8.0123337599827167</c:v>
                  </c:pt>
                  <c:pt idx="2">
                    <c:v>8.2923650869706034</c:v>
                  </c:pt>
                  <c:pt idx="3">
                    <c:v>10.25133391153725</c:v>
                  </c:pt>
                  <c:pt idx="4">
                    <c:v>13.861059525279101</c:v>
                  </c:pt>
                  <c:pt idx="5">
                    <c:v>8.346984279710453</c:v>
                  </c:pt>
                  <c:pt idx="6">
                    <c:v>14.080989291802151</c:v>
                  </c:pt>
                  <c:pt idx="7">
                    <c:v>17.797116817969115</c:v>
                  </c:pt>
                  <c:pt idx="8">
                    <c:v>41.409523740898763</c:v>
                  </c:pt>
                  <c:pt idx="9">
                    <c:v>56.805785907413906</c:v>
                  </c:pt>
                </c:numCache>
              </c:numRef>
            </c:plus>
            <c:minus>
              <c:numRef>
                <c:f>(Feuil1!$F$27;Feuil1!$H$27;Feuil1!$J$27;Feuil1!$L$27;Feuil1!$N$27;Feuil1!$P$27;Feuil1!$R$27;Feuil1!$T$27;Feuil1!$V$27;Feuil1!$X$27)</c:f>
                <c:numCache>
                  <c:formatCode>General</c:formatCode>
                  <c:ptCount val="10"/>
                  <c:pt idx="0">
                    <c:v>4.4419050231181973</c:v>
                  </c:pt>
                  <c:pt idx="1">
                    <c:v>8.0123337599827167</c:v>
                  </c:pt>
                  <c:pt idx="2">
                    <c:v>8.2923650869706034</c:v>
                  </c:pt>
                  <c:pt idx="3">
                    <c:v>10.25133391153725</c:v>
                  </c:pt>
                  <c:pt idx="4">
                    <c:v>13.861059525279101</c:v>
                  </c:pt>
                  <c:pt idx="5">
                    <c:v>8.346984279710453</c:v>
                  </c:pt>
                  <c:pt idx="6">
                    <c:v>14.080989291802151</c:v>
                  </c:pt>
                  <c:pt idx="7">
                    <c:v>17.797116817969115</c:v>
                  </c:pt>
                  <c:pt idx="8">
                    <c:v>41.409523740898763</c:v>
                  </c:pt>
                  <c:pt idx="9">
                    <c:v>56.805785907413906</c:v>
                  </c:pt>
                </c:numCache>
              </c:numRef>
            </c:minus>
          </c:errBars>
          <c:cat>
            <c:numRef>
              <c:f>(Feuil1!$F$3;Feuil1!$H$3;Feuil1!$J$3;Feuil1!$L$3;Feuil1!$N$3;Feuil1!$P$3;Feuil1!$R$3;Feuil1!$T$3;Feuil1!$V$3;Feuil1!$X$3)</c:f>
              <c:numCache>
                <c:formatCode>General</c:formatCode>
                <c:ptCount val="10"/>
                <c:pt idx="0">
                  <c:v>6</c:v>
                </c:pt>
                <c:pt idx="1">
                  <c:v>8</c:v>
                </c:pt>
                <c:pt idx="2">
                  <c:v>10</c:v>
                </c:pt>
                <c:pt idx="3">
                  <c:v>13</c:v>
                </c:pt>
                <c:pt idx="4">
                  <c:v>15</c:v>
                </c:pt>
                <c:pt idx="5">
                  <c:v>17</c:v>
                </c:pt>
                <c:pt idx="6">
                  <c:v>22</c:v>
                </c:pt>
                <c:pt idx="7">
                  <c:v>24</c:v>
                </c:pt>
                <c:pt idx="8">
                  <c:v>26</c:v>
                </c:pt>
                <c:pt idx="9">
                  <c:v>29</c:v>
                </c:pt>
              </c:numCache>
            </c:numRef>
          </c:cat>
          <c:val>
            <c:numRef>
              <c:f>(Feuil1!$F$26;Feuil1!$H$26;Feuil1!$J$26;Feuil1!$L$26;Feuil1!$N$26;Feuil1!$P$26;Feuil1!$R$26;Feuil1!$T$26;Feuil1!$V$26;Feuil1!$X$26)</c:f>
              <c:numCache>
                <c:formatCode>General</c:formatCode>
                <c:ptCount val="10"/>
                <c:pt idx="0">
                  <c:v>35.274383461666531</c:v>
                </c:pt>
                <c:pt idx="1">
                  <c:v>37.885380596666579</c:v>
                </c:pt>
                <c:pt idx="2">
                  <c:v>31.267426373999953</c:v>
                </c:pt>
                <c:pt idx="3">
                  <c:v>43.610796355185201</c:v>
                </c:pt>
                <c:pt idx="4">
                  <c:v>45.210681624999992</c:v>
                </c:pt>
                <c:pt idx="5">
                  <c:v>34.669771856333327</c:v>
                </c:pt>
                <c:pt idx="6">
                  <c:v>61.713065122916646</c:v>
                </c:pt>
                <c:pt idx="7">
                  <c:v>67.37600384933333</c:v>
                </c:pt>
                <c:pt idx="8">
                  <c:v>103.66522442566671</c:v>
                </c:pt>
                <c:pt idx="9">
                  <c:v>131.09255184666671</c:v>
                </c:pt>
              </c:numCache>
            </c:numRef>
          </c:val>
        </c:ser>
        <c:dLbls/>
        <c:marker val="1"/>
        <c:axId val="109450368"/>
        <c:axId val="109451904"/>
      </c:lineChart>
      <c:catAx>
        <c:axId val="109450368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800" b="1"/>
            </a:pPr>
            <a:endParaRPr lang="fr-FR"/>
          </a:p>
        </c:txPr>
        <c:crossAx val="109451904"/>
        <c:crosses val="autoZero"/>
        <c:auto val="1"/>
        <c:lblAlgn val="ctr"/>
        <c:lblOffset val="100"/>
      </c:catAx>
      <c:valAx>
        <c:axId val="10945190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9450368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E$15;Feuil1!$K$15)</c:f>
                <c:numCache>
                  <c:formatCode>General</c:formatCode>
                  <c:ptCount val="2"/>
                  <c:pt idx="0">
                    <c:v>4.1912738244283574</c:v>
                  </c:pt>
                  <c:pt idx="1">
                    <c:v>9.35219529582880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E$1:$F$1</c:f>
              <c:strCache>
                <c:ptCount val="2"/>
                <c:pt idx="0">
                  <c:v>DMSO</c:v>
                </c:pt>
                <c:pt idx="1">
                  <c:v>Inhibitor E2F 20µM</c:v>
                </c:pt>
              </c:strCache>
            </c:strRef>
          </c:cat>
          <c:val>
            <c:numRef>
              <c:f>(Feuil1!$E$14;Feuil1!$K$14)</c:f>
              <c:numCache>
                <c:formatCode>0.00</c:formatCode>
                <c:ptCount val="2"/>
                <c:pt idx="0">
                  <c:v>100</c:v>
                </c:pt>
                <c:pt idx="1">
                  <c:v>100</c:v>
                </c:pt>
              </c:numCache>
            </c:numRef>
          </c:val>
        </c:ser>
        <c:ser>
          <c:idx val="1"/>
          <c:order val="1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F$15;Feuil1!$L$15)</c:f>
                <c:numCache>
                  <c:formatCode>General</c:formatCode>
                  <c:ptCount val="2"/>
                  <c:pt idx="0">
                    <c:v>11.210263817778568</c:v>
                  </c:pt>
                  <c:pt idx="1">
                    <c:v>9.352195295829082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euil1!$E$1:$F$1</c:f>
              <c:strCache>
                <c:ptCount val="2"/>
                <c:pt idx="0">
                  <c:v>DMSO</c:v>
                </c:pt>
                <c:pt idx="1">
                  <c:v>Inhibitor E2F 20µM</c:v>
                </c:pt>
              </c:strCache>
            </c:strRef>
          </c:cat>
          <c:val>
            <c:numRef>
              <c:f>(Feuil1!$F$14;Feuil1!$L$14)</c:f>
              <c:numCache>
                <c:formatCode>0.00</c:formatCode>
                <c:ptCount val="2"/>
                <c:pt idx="0">
                  <c:v>98.657718120805029</c:v>
                </c:pt>
                <c:pt idx="1">
                  <c:v>93.877551020408148</c:v>
                </c:pt>
              </c:numCache>
            </c:numRef>
          </c:val>
        </c:ser>
        <c:dLbls/>
        <c:axId val="109507328"/>
        <c:axId val="109508864"/>
      </c:barChart>
      <c:catAx>
        <c:axId val="109507328"/>
        <c:scaling>
          <c:orientation val="minMax"/>
        </c:scaling>
        <c:axPos val="b"/>
        <c:tickLblPos val="nextTo"/>
        <c:txPr>
          <a:bodyPr/>
          <a:lstStyle/>
          <a:p>
            <a:pPr>
              <a:defRPr sz="600" b="1"/>
            </a:pPr>
            <a:endParaRPr lang="fr-FR"/>
          </a:p>
        </c:txPr>
        <c:crossAx val="109508864"/>
        <c:crosses val="autoZero"/>
        <c:auto val="1"/>
        <c:lblAlgn val="ctr"/>
        <c:lblOffset val="25"/>
      </c:catAx>
      <c:valAx>
        <c:axId val="109508864"/>
        <c:scaling>
          <c:orientation val="minMax"/>
          <c:max val="120"/>
          <c:min val="0"/>
        </c:scaling>
        <c:axPos val="l"/>
        <c:numFmt formatCode="0" sourceLinked="0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9507328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dPt>
            <c:idx val="1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plus>
              <c:numRef>
                <c:f>(Feuil2!$D$9;Feuil2!$D$25)</c:f>
                <c:numCache>
                  <c:formatCode>General</c:formatCode>
                  <c:ptCount val="2"/>
                  <c:pt idx="0">
                    <c:v>0.12361279649288001</c:v>
                  </c:pt>
                  <c:pt idx="1">
                    <c:v>3.34352608284528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Feuil2!$B$3;Feuil2!$B$19)</c:f>
              <c:strCache>
                <c:ptCount val="2"/>
                <c:pt idx="0">
                  <c:v>Labra</c:v>
                </c:pt>
                <c:pt idx="1">
                  <c:v>Inhi E2F</c:v>
                </c:pt>
              </c:strCache>
            </c:strRef>
          </c:cat>
          <c:val>
            <c:numRef>
              <c:f>(Feuil2!$D$8;Feuil2!$D$24)</c:f>
              <c:numCache>
                <c:formatCode>General</c:formatCode>
                <c:ptCount val="2"/>
                <c:pt idx="0">
                  <c:v>1.081</c:v>
                </c:pt>
                <c:pt idx="1">
                  <c:v>9.9000000000000019E-2</c:v>
                </c:pt>
              </c:numCache>
            </c:numRef>
          </c:val>
        </c:ser>
        <c:dLbls/>
        <c:axId val="109701376"/>
        <c:axId val="109703168"/>
      </c:barChart>
      <c:catAx>
        <c:axId val="109701376"/>
        <c:scaling>
          <c:orientation val="minMax"/>
        </c:scaling>
        <c:axPos val="b"/>
        <c:tickLblPos val="nextTo"/>
        <c:crossAx val="109703168"/>
        <c:crosses val="autoZero"/>
        <c:auto val="1"/>
        <c:lblAlgn val="ctr"/>
        <c:lblOffset val="100"/>
      </c:catAx>
      <c:valAx>
        <c:axId val="10970316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9701376"/>
        <c:crosses val="autoZero"/>
        <c:crossBetween val="between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E$15;Feuil1!$S$32;Feuil1!$L$15;Feuil1!$L$32;Feuil1!$S$15;Feuil1!$E$32;Feuil1!$L$49)</c:f>
                <c:numCache>
                  <c:formatCode>General</c:formatCode>
                  <c:ptCount val="7"/>
                  <c:pt idx="0">
                    <c:v>11.176663957796601</c:v>
                  </c:pt>
                  <c:pt idx="1">
                    <c:v>7.1428571428571388</c:v>
                  </c:pt>
                  <c:pt idx="2">
                    <c:v>14.83367139933206</c:v>
                  </c:pt>
                  <c:pt idx="3">
                    <c:v>4.0018174541435707</c:v>
                  </c:pt>
                  <c:pt idx="4">
                    <c:v>3.6243168644720556</c:v>
                  </c:pt>
                  <c:pt idx="5">
                    <c:v>8.3319558090106156</c:v>
                  </c:pt>
                  <c:pt idx="6">
                    <c:v>8.92142571199771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E$14;Feuil1!$S$31;Feuil1!$L$14;Feuil1!$L$31;Feuil1!$S$14)</c:f>
              <c:numCache>
                <c:formatCode>0.00</c:formatCode>
                <c:ptCount val="5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</c:numCache>
            </c:numRef>
          </c:val>
        </c:ser>
        <c:ser>
          <c:idx val="1"/>
          <c:order val="1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(Feuil1!$F$15;Feuil1!$T$32;Feuil1!$M$15;Feuil1!$M$32;Feuil1!$T$15;Feuil1!$F$32;Feuil1!$M$49)</c:f>
                <c:numCache>
                  <c:formatCode>General</c:formatCode>
                  <c:ptCount val="7"/>
                  <c:pt idx="0">
                    <c:v>7.8334627264201719</c:v>
                  </c:pt>
                  <c:pt idx="1">
                    <c:v>3.5714285714285787</c:v>
                  </c:pt>
                  <c:pt idx="2">
                    <c:v>4.9381811702611209</c:v>
                  </c:pt>
                  <c:pt idx="3">
                    <c:v>2.0099016205946749</c:v>
                  </c:pt>
                  <c:pt idx="4">
                    <c:v>7.5446171880631434</c:v>
                  </c:pt>
                  <c:pt idx="5">
                    <c:v>11.354541815269974</c:v>
                  </c:pt>
                  <c:pt idx="6">
                    <c:v>10.7854777646724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Feuil1!$F$14;Feuil1!$T$31;Feuil1!$M$14;Feuil1!$M$31;Feuil1!$T$14)</c:f>
              <c:numCache>
                <c:formatCode>0.00</c:formatCode>
                <c:ptCount val="5"/>
                <c:pt idx="0">
                  <c:v>47.008547008546998</c:v>
                </c:pt>
                <c:pt idx="1">
                  <c:v>17.857142857142836</c:v>
                </c:pt>
                <c:pt idx="2">
                  <c:v>33.478260869565197</c:v>
                </c:pt>
                <c:pt idx="3">
                  <c:v>12.719298245614029</c:v>
                </c:pt>
                <c:pt idx="4">
                  <c:v>29.68036529680365</c:v>
                </c:pt>
              </c:numCache>
            </c:numRef>
          </c:val>
        </c:ser>
        <c:dLbls/>
        <c:axId val="109790720"/>
        <c:axId val="109792256"/>
      </c:barChart>
      <c:catAx>
        <c:axId val="109790720"/>
        <c:scaling>
          <c:orientation val="minMax"/>
        </c:scaling>
        <c:axPos val="b"/>
        <c:tickLblPos val="nextTo"/>
        <c:crossAx val="109792256"/>
        <c:crosses val="autoZero"/>
        <c:auto val="1"/>
        <c:lblAlgn val="ctr"/>
        <c:lblOffset val="100"/>
      </c:catAx>
      <c:valAx>
        <c:axId val="109792256"/>
        <c:scaling>
          <c:orientation val="minMax"/>
          <c:max val="120"/>
        </c:scaling>
        <c:axPos val="l"/>
        <c:numFmt formatCode="0" sourceLinked="0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09790720"/>
        <c:crosses val="autoZero"/>
        <c:crossBetween val="between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hart>
    <c:plotArea>
      <c:layout>
        <c:manualLayout>
          <c:layoutTarget val="inner"/>
          <c:xMode val="edge"/>
          <c:yMode val="edge"/>
          <c:x val="6.3595876602381196E-2"/>
          <c:y val="4.7182034406927101E-2"/>
          <c:w val="0.84384464985355212"/>
          <c:h val="0.82753404085303794"/>
        </c:manualLayout>
      </c:layout>
      <c:barChart>
        <c:barDir val="col"/>
        <c:grouping val="clustered"/>
        <c:ser>
          <c:idx val="0"/>
          <c:order val="0"/>
          <c:tx>
            <c:strRef>
              <c:f>'Replicat 1'!$AA$42</c:f>
              <c:strCache>
                <c:ptCount val="1"/>
                <c:pt idx="0">
                  <c:v>siCTR</c:v>
                </c:pt>
              </c:strCache>
            </c:strRef>
          </c:tx>
          <c:cat>
            <c:strRef>
              <c:f>'Replicat 1'!$Z$44:$Z$53</c:f>
              <c:strCache>
                <c:ptCount val="10"/>
                <c:pt idx="0">
                  <c:v>CCNE1</c:v>
                </c:pt>
                <c:pt idx="1">
                  <c:v>MYLB2</c:v>
                </c:pt>
                <c:pt idx="2">
                  <c:v>BIRC5</c:v>
                </c:pt>
                <c:pt idx="3">
                  <c:v>CCNB2</c:v>
                </c:pt>
                <c:pt idx="4">
                  <c:v>CDC6</c:v>
                </c:pt>
                <c:pt idx="5">
                  <c:v>CDC2</c:v>
                </c:pt>
                <c:pt idx="6">
                  <c:v>C-JUN</c:v>
                </c:pt>
                <c:pt idx="7">
                  <c:v>BCL2</c:v>
                </c:pt>
                <c:pt idx="8">
                  <c:v>BRCA1</c:v>
                </c:pt>
                <c:pt idx="9">
                  <c:v>TP53</c:v>
                </c:pt>
              </c:strCache>
            </c:strRef>
          </c:cat>
          <c:val>
            <c:numRef>
              <c:f>'Replicat 1'!$AA$44:$AA$53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strRef>
              <c:f>'Replicat 1'!$AB$42</c:f>
              <c:strCache>
                <c:ptCount val="1"/>
                <c:pt idx="0">
                  <c:v>siE2F1</c:v>
                </c:pt>
              </c:strCache>
            </c:strRef>
          </c:tx>
          <c:errBars>
            <c:errBarType val="plus"/>
            <c:errValType val="cust"/>
            <c:plus>
              <c:numRef>
                <c:f>'Replicat 1'!$AB$59:$AB$68</c:f>
                <c:numCache>
                  <c:formatCode>General</c:formatCode>
                  <c:ptCount val="10"/>
                  <c:pt idx="0">
                    <c:v>0.14835096117468899</c:v>
                  </c:pt>
                  <c:pt idx="1">
                    <c:v>0.45647978777667408</c:v>
                  </c:pt>
                  <c:pt idx="2">
                    <c:v>6.5497775451075109E-3</c:v>
                  </c:pt>
                  <c:pt idx="3">
                    <c:v>0.37367001532611605</c:v>
                  </c:pt>
                  <c:pt idx="4">
                    <c:v>0.10526366947738602</c:v>
                  </c:pt>
                  <c:pt idx="5">
                    <c:v>0.35378751580545109</c:v>
                  </c:pt>
                  <c:pt idx="6">
                    <c:v>3.3712073354313997E-2</c:v>
                  </c:pt>
                  <c:pt idx="7">
                    <c:v>0.200574465729914</c:v>
                  </c:pt>
                  <c:pt idx="8">
                    <c:v>6.57819514144454E-2</c:v>
                  </c:pt>
                  <c:pt idx="9">
                    <c:v>0.611714794779417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Replicat 1'!$Z$44:$Z$53</c:f>
              <c:strCache>
                <c:ptCount val="10"/>
                <c:pt idx="0">
                  <c:v>CCNE1</c:v>
                </c:pt>
                <c:pt idx="1">
                  <c:v>MYLB2</c:v>
                </c:pt>
                <c:pt idx="2">
                  <c:v>BIRC5</c:v>
                </c:pt>
                <c:pt idx="3">
                  <c:v>CCNB2</c:v>
                </c:pt>
                <c:pt idx="4">
                  <c:v>CDC6</c:v>
                </c:pt>
                <c:pt idx="5">
                  <c:v>CDC2</c:v>
                </c:pt>
                <c:pt idx="6">
                  <c:v>C-JUN</c:v>
                </c:pt>
                <c:pt idx="7">
                  <c:v>BCL2</c:v>
                </c:pt>
                <c:pt idx="8">
                  <c:v>BRCA1</c:v>
                </c:pt>
                <c:pt idx="9">
                  <c:v>TP53</c:v>
                </c:pt>
              </c:strCache>
            </c:strRef>
          </c:cat>
          <c:val>
            <c:numRef>
              <c:f>'Replicat 1'!$AB$44:$AB$53</c:f>
              <c:numCache>
                <c:formatCode>General</c:formatCode>
                <c:ptCount val="10"/>
                <c:pt idx="0">
                  <c:v>0.84129668765282106</c:v>
                </c:pt>
                <c:pt idx="1">
                  <c:v>0.63997125535554422</c:v>
                </c:pt>
                <c:pt idx="2">
                  <c:v>0.22980214931225601</c:v>
                </c:pt>
                <c:pt idx="3">
                  <c:v>1.1605527270642073</c:v>
                </c:pt>
                <c:pt idx="4">
                  <c:v>0.46900382452275102</c:v>
                </c:pt>
                <c:pt idx="5">
                  <c:v>0.56382480641846422</c:v>
                </c:pt>
                <c:pt idx="6">
                  <c:v>0.77172723714930924</c:v>
                </c:pt>
                <c:pt idx="7">
                  <c:v>0.54419142846532009</c:v>
                </c:pt>
                <c:pt idx="8">
                  <c:v>0.27722271305495511</c:v>
                </c:pt>
                <c:pt idx="9">
                  <c:v>1.5774708821493977</c:v>
                </c:pt>
              </c:numCache>
            </c:numRef>
          </c:val>
        </c:ser>
        <c:ser>
          <c:idx val="2"/>
          <c:order val="2"/>
          <c:tx>
            <c:strRef>
              <c:f>'Replicat 1'!$AC$42</c:f>
              <c:strCache>
                <c:ptCount val="1"/>
                <c:pt idx="0">
                  <c:v>DMSO</c:v>
                </c:pt>
              </c:strCache>
            </c:strRef>
          </c:tx>
          <c:cat>
            <c:strRef>
              <c:f>'Replicat 1'!$Z$44:$Z$53</c:f>
              <c:strCache>
                <c:ptCount val="10"/>
                <c:pt idx="0">
                  <c:v>CCNE1</c:v>
                </c:pt>
                <c:pt idx="1">
                  <c:v>MYLB2</c:v>
                </c:pt>
                <c:pt idx="2">
                  <c:v>BIRC5</c:v>
                </c:pt>
                <c:pt idx="3">
                  <c:v>CCNB2</c:v>
                </c:pt>
                <c:pt idx="4">
                  <c:v>CDC6</c:v>
                </c:pt>
                <c:pt idx="5">
                  <c:v>CDC2</c:v>
                </c:pt>
                <c:pt idx="6">
                  <c:v>C-JUN</c:v>
                </c:pt>
                <c:pt idx="7">
                  <c:v>BCL2</c:v>
                </c:pt>
                <c:pt idx="8">
                  <c:v>BRCA1</c:v>
                </c:pt>
                <c:pt idx="9">
                  <c:v>TP53</c:v>
                </c:pt>
              </c:strCache>
            </c:strRef>
          </c:cat>
          <c:val>
            <c:numRef>
              <c:f>'Replicat 1'!$AC$44:$AC$53</c:f>
              <c:numCache>
                <c:formatCode>General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</c:numCache>
            </c:numRef>
          </c:val>
        </c:ser>
        <c:ser>
          <c:idx val="3"/>
          <c:order val="3"/>
          <c:tx>
            <c:strRef>
              <c:f>'Replicat 1'!$AD$42</c:f>
              <c:strCache>
                <c:ptCount val="1"/>
                <c:pt idx="0">
                  <c:v>HLM</c:v>
                </c:pt>
              </c:strCache>
            </c:strRef>
          </c:tx>
          <c:errBars>
            <c:errBarType val="plus"/>
            <c:errValType val="cust"/>
            <c:plus>
              <c:numRef>
                <c:f>'Replicat 1'!$AD$59:$AD$68</c:f>
                <c:numCache>
                  <c:formatCode>General</c:formatCode>
                  <c:ptCount val="10"/>
                  <c:pt idx="0">
                    <c:v>0.23369874662225501</c:v>
                  </c:pt>
                  <c:pt idx="1">
                    <c:v>8.7869619655788198E-2</c:v>
                  </c:pt>
                  <c:pt idx="2">
                    <c:v>3.4910111300067305E-2</c:v>
                  </c:pt>
                  <c:pt idx="3">
                    <c:v>0.16044926738124904</c:v>
                  </c:pt>
                  <c:pt idx="4">
                    <c:v>5.0107451660988407E-2</c:v>
                  </c:pt>
                  <c:pt idx="5">
                    <c:v>7.2939043627818102E-3</c:v>
                  </c:pt>
                  <c:pt idx="6">
                    <c:v>0.260081540363377</c:v>
                  </c:pt>
                  <c:pt idx="7">
                    <c:v>0.23069758195266102</c:v>
                  </c:pt>
                  <c:pt idx="8">
                    <c:v>5.3998081961379299E-2</c:v>
                  </c:pt>
                  <c:pt idx="9">
                    <c:v>8.559469705619422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Replicat 1'!$Z$44:$Z$53</c:f>
              <c:strCache>
                <c:ptCount val="10"/>
                <c:pt idx="0">
                  <c:v>CCNE1</c:v>
                </c:pt>
                <c:pt idx="1">
                  <c:v>MYLB2</c:v>
                </c:pt>
                <c:pt idx="2">
                  <c:v>BIRC5</c:v>
                </c:pt>
                <c:pt idx="3">
                  <c:v>CCNB2</c:v>
                </c:pt>
                <c:pt idx="4">
                  <c:v>CDC6</c:v>
                </c:pt>
                <c:pt idx="5">
                  <c:v>CDC2</c:v>
                </c:pt>
                <c:pt idx="6">
                  <c:v>C-JUN</c:v>
                </c:pt>
                <c:pt idx="7">
                  <c:v>BCL2</c:v>
                </c:pt>
                <c:pt idx="8">
                  <c:v>BRCA1</c:v>
                </c:pt>
                <c:pt idx="9">
                  <c:v>TP53</c:v>
                </c:pt>
              </c:strCache>
            </c:strRef>
          </c:cat>
          <c:val>
            <c:numRef>
              <c:f>'Replicat 1'!$AD$44:$AD$53</c:f>
              <c:numCache>
                <c:formatCode>General</c:formatCode>
                <c:ptCount val="10"/>
                <c:pt idx="0">
                  <c:v>0.81883762368236002</c:v>
                </c:pt>
                <c:pt idx="1">
                  <c:v>1.1649973302814121</c:v>
                </c:pt>
                <c:pt idx="2">
                  <c:v>0.10166331286301501</c:v>
                </c:pt>
                <c:pt idx="3">
                  <c:v>0.67967058671159619</c:v>
                </c:pt>
                <c:pt idx="4">
                  <c:v>0.23208043067608103</c:v>
                </c:pt>
                <c:pt idx="5">
                  <c:v>0.73530975361284212</c:v>
                </c:pt>
                <c:pt idx="6">
                  <c:v>0.93150278718880997</c:v>
                </c:pt>
                <c:pt idx="7">
                  <c:v>1.121467760820458</c:v>
                </c:pt>
                <c:pt idx="8">
                  <c:v>0.32238546333085522</c:v>
                </c:pt>
                <c:pt idx="9">
                  <c:v>1.4985351171667731</c:v>
                </c:pt>
              </c:numCache>
            </c:numRef>
          </c:val>
        </c:ser>
        <c:dLbls/>
        <c:axId val="109887872"/>
        <c:axId val="109889408"/>
      </c:barChart>
      <c:catAx>
        <c:axId val="109887872"/>
        <c:scaling>
          <c:orientation val="minMax"/>
        </c:scaling>
        <c:axPos val="b"/>
        <c:tickLblPos val="nextTo"/>
        <c:txPr>
          <a:bodyPr/>
          <a:lstStyle/>
          <a:p>
            <a:pPr>
              <a:defRPr sz="6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9889408"/>
        <c:crosses val="autoZero"/>
        <c:auto val="1"/>
        <c:lblAlgn val="ctr"/>
        <c:lblOffset val="100"/>
      </c:catAx>
      <c:valAx>
        <c:axId val="109889408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098878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8.2319753509072197E-2"/>
          <c:y val="9.1327061223342498E-2"/>
          <c:w val="0.10028894214310201"/>
          <c:h val="0.24789022335189803"/>
        </c:manualLayout>
      </c:layout>
      <c:txPr>
        <a:bodyPr/>
        <a:lstStyle/>
        <a:p>
          <a:pPr>
            <a:defRPr sz="600" b="1">
              <a:latin typeface="Arial" pitchFamily="34" charset="0"/>
              <a:cs typeface="Arial" pitchFamily="34" charset="0"/>
            </a:defRPr>
          </a:pPr>
          <a:endParaRPr lang="fr-FR"/>
        </a:p>
      </c:txPr>
    </c:legend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DC8511-E78E-4166-BD64-311A3B883A0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3C3C8E-4E15-4EFB-88B7-FFD1E53F3C6A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1390418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44665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28840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86287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254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133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85582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698649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05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098532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77843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99621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CEB44-3531-40EF-8C0C-5006F9CAD885}" type="datetimeFigureOut">
              <a:rPr lang="fr-FR" smtClean="0"/>
              <a:pPr/>
              <a:t>11/03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2FE40-1FA4-4D3A-ABAA-AE1CA47DD8D8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1346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13" Type="http://schemas.openxmlformats.org/officeDocument/2006/relationships/chart" Target="../charts/chart4.xml"/><Relationship Id="rId18" Type="http://schemas.openxmlformats.org/officeDocument/2006/relationships/image" Target="../media/image12.jpeg"/><Relationship Id="rId3" Type="http://schemas.openxmlformats.org/officeDocument/2006/relationships/chart" Target="../charts/chart1.xml"/><Relationship Id="rId21" Type="http://schemas.openxmlformats.org/officeDocument/2006/relationships/image" Target="../media/image14.jpeg"/><Relationship Id="rId7" Type="http://schemas.openxmlformats.org/officeDocument/2006/relationships/image" Target="../media/image4.jpeg"/><Relationship Id="rId12" Type="http://schemas.openxmlformats.org/officeDocument/2006/relationships/image" Target="../media/image8.jpeg"/><Relationship Id="rId17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0.jpeg"/><Relationship Id="rId20" Type="http://schemas.openxmlformats.org/officeDocument/2006/relationships/image" Target="../media/image13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11" Type="http://schemas.openxmlformats.org/officeDocument/2006/relationships/image" Target="../media/image7.jpeg"/><Relationship Id="rId5" Type="http://schemas.openxmlformats.org/officeDocument/2006/relationships/image" Target="../media/image3.jpeg"/><Relationship Id="rId15" Type="http://schemas.openxmlformats.org/officeDocument/2006/relationships/image" Target="../media/image9.jpeg"/><Relationship Id="rId23" Type="http://schemas.openxmlformats.org/officeDocument/2006/relationships/image" Target="../media/image16.jpeg"/><Relationship Id="rId10" Type="http://schemas.openxmlformats.org/officeDocument/2006/relationships/chart" Target="../charts/chart3.xml"/><Relationship Id="rId19" Type="http://schemas.openxmlformats.org/officeDocument/2006/relationships/chart" Target="../charts/chart6.xml"/><Relationship Id="rId4" Type="http://schemas.openxmlformats.org/officeDocument/2006/relationships/image" Target="../media/image2.jpeg"/><Relationship Id="rId9" Type="http://schemas.openxmlformats.org/officeDocument/2006/relationships/image" Target="../media/image6.jpeg"/><Relationship Id="rId14" Type="http://schemas.openxmlformats.org/officeDocument/2006/relationships/chart" Target="../charts/chart5.xml"/><Relationship Id="rId22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6" name="Connecteur droit 295"/>
          <p:cNvCxnSpPr/>
          <p:nvPr/>
        </p:nvCxnSpPr>
        <p:spPr>
          <a:xfrm flipV="1">
            <a:off x="6068614" y="1470756"/>
            <a:ext cx="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Connecteur droit 296"/>
          <p:cNvCxnSpPr/>
          <p:nvPr/>
        </p:nvCxnSpPr>
        <p:spPr>
          <a:xfrm flipV="1">
            <a:off x="6068614" y="1661256"/>
            <a:ext cx="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ZoneTexte 297"/>
          <p:cNvSpPr txBox="1"/>
          <p:nvPr/>
        </p:nvSpPr>
        <p:spPr>
          <a:xfrm>
            <a:off x="6075343" y="157476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99" name="ZoneTexte 298"/>
          <p:cNvSpPr txBox="1"/>
          <p:nvPr/>
        </p:nvSpPr>
        <p:spPr>
          <a:xfrm>
            <a:off x="6075343" y="1377917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cxnSp>
        <p:nvCxnSpPr>
          <p:cNvPr id="320" name="Connecteur droit 319"/>
          <p:cNvCxnSpPr/>
          <p:nvPr/>
        </p:nvCxnSpPr>
        <p:spPr>
          <a:xfrm flipV="1">
            <a:off x="6068626" y="1282524"/>
            <a:ext cx="7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ZoneTexte 341"/>
          <p:cNvSpPr txBox="1"/>
          <p:nvPr/>
        </p:nvSpPr>
        <p:spPr>
          <a:xfrm>
            <a:off x="6075355" y="118968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58kDa</a:t>
            </a:r>
          </a:p>
        </p:txBody>
      </p:sp>
      <p:sp>
        <p:nvSpPr>
          <p:cNvPr id="227" name="Line 311"/>
          <p:cNvSpPr>
            <a:spLocks noChangeShapeType="1"/>
          </p:cNvSpPr>
          <p:nvPr/>
        </p:nvSpPr>
        <p:spPr bwMode="auto">
          <a:xfrm>
            <a:off x="6393806" y="6922439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8" name="Line 311"/>
          <p:cNvSpPr>
            <a:spLocks noChangeShapeType="1"/>
          </p:cNvSpPr>
          <p:nvPr/>
        </p:nvSpPr>
        <p:spPr bwMode="auto">
          <a:xfrm>
            <a:off x="6394806" y="6719280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Line 311"/>
          <p:cNvSpPr>
            <a:spLocks noChangeShapeType="1"/>
          </p:cNvSpPr>
          <p:nvPr/>
        </p:nvSpPr>
        <p:spPr bwMode="auto">
          <a:xfrm>
            <a:off x="6394806" y="7114201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ZoneTexte 115"/>
          <p:cNvSpPr txBox="1"/>
          <p:nvPr/>
        </p:nvSpPr>
        <p:spPr>
          <a:xfrm>
            <a:off x="6460296" y="6639115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234" name="ZoneTexte 116"/>
          <p:cNvSpPr txBox="1"/>
          <p:nvPr/>
        </p:nvSpPr>
        <p:spPr>
          <a:xfrm>
            <a:off x="6460296" y="7034034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36" name="ZoneTexte 116"/>
          <p:cNvSpPr txBox="1"/>
          <p:nvPr/>
        </p:nvSpPr>
        <p:spPr>
          <a:xfrm>
            <a:off x="6459296" y="6842272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220" name="Line 311"/>
          <p:cNvSpPr>
            <a:spLocks noChangeShapeType="1"/>
          </p:cNvSpPr>
          <p:nvPr/>
        </p:nvSpPr>
        <p:spPr bwMode="auto">
          <a:xfrm>
            <a:off x="1640272" y="670940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2" name="Line 311"/>
          <p:cNvSpPr>
            <a:spLocks noChangeShapeType="1"/>
          </p:cNvSpPr>
          <p:nvPr/>
        </p:nvSpPr>
        <p:spPr bwMode="auto">
          <a:xfrm>
            <a:off x="1641272" y="6904828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ZoneTexte 116"/>
          <p:cNvSpPr txBox="1"/>
          <p:nvPr/>
        </p:nvSpPr>
        <p:spPr>
          <a:xfrm>
            <a:off x="1706762" y="682466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26" name="ZoneTexte 116"/>
          <p:cNvSpPr txBox="1"/>
          <p:nvPr/>
        </p:nvSpPr>
        <p:spPr>
          <a:xfrm>
            <a:off x="1705762" y="6629241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202" name="Line 311"/>
          <p:cNvSpPr>
            <a:spLocks noChangeShapeType="1"/>
          </p:cNvSpPr>
          <p:nvPr/>
        </p:nvSpPr>
        <p:spPr bwMode="auto">
          <a:xfrm>
            <a:off x="2085680" y="2506217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Line 311"/>
          <p:cNvSpPr>
            <a:spLocks noChangeShapeType="1"/>
          </p:cNvSpPr>
          <p:nvPr/>
        </p:nvSpPr>
        <p:spPr bwMode="auto">
          <a:xfrm>
            <a:off x="2086680" y="2318494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Line 311"/>
          <p:cNvSpPr>
            <a:spLocks noChangeShapeType="1"/>
          </p:cNvSpPr>
          <p:nvPr/>
        </p:nvSpPr>
        <p:spPr bwMode="auto">
          <a:xfrm>
            <a:off x="2086680" y="2712209"/>
            <a:ext cx="126044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ZoneTexte 115"/>
          <p:cNvSpPr txBox="1"/>
          <p:nvPr/>
        </p:nvSpPr>
        <p:spPr>
          <a:xfrm>
            <a:off x="2152170" y="2238329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211" name="ZoneTexte 116"/>
          <p:cNvSpPr txBox="1"/>
          <p:nvPr/>
        </p:nvSpPr>
        <p:spPr>
          <a:xfrm>
            <a:off x="2152170" y="2632042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90kDa</a:t>
            </a:r>
          </a:p>
        </p:txBody>
      </p:sp>
      <p:sp>
        <p:nvSpPr>
          <p:cNvPr id="213" name="ZoneTexte 116"/>
          <p:cNvSpPr txBox="1"/>
          <p:nvPr/>
        </p:nvSpPr>
        <p:spPr>
          <a:xfrm>
            <a:off x="2151170" y="2426050"/>
            <a:ext cx="37221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500" b="1" dirty="0" smtClean="0">
                <a:latin typeface="Arial" pitchFamily="34" charset="0"/>
                <a:cs typeface="Arial" pitchFamily="34" charset="0"/>
                <a:sym typeface="Webdings"/>
              </a:rPr>
              <a:t>60kDa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5332004" y="49213"/>
            <a:ext cx="1463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1500" b="1" dirty="0" err="1" smtClean="0">
                <a:latin typeface="Arial" pitchFamily="34" charset="0"/>
                <a:cs typeface="Arial" pitchFamily="34" charset="0"/>
                <a:sym typeface="Webdings"/>
              </a:rPr>
              <a:t>Supp</a:t>
            </a:r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 Figure 1</a:t>
            </a:r>
          </a:p>
        </p:txBody>
      </p:sp>
      <p:pic>
        <p:nvPicPr>
          <p:cNvPr id="237" name="Picture 16" descr="C:\Users\Flo\Desktop\Thèse\Projet E2F1\Expériences\Blot\Blot 14-1-15 Tumeurs Inhib PLX 4j et Cinetique Inhib A 375\14-1-15012.jpg"/>
          <p:cNvPicPr preferRelativeResize="0">
            <a:picLocks noChangeArrowheads="1"/>
          </p:cNvPicPr>
          <p:nvPr/>
        </p:nvPicPr>
        <p:blipFill>
          <a:blip r:embed="rId2" cstate="print"/>
          <a:srcRect l="36452" t="73668" r="43179" b="22503"/>
          <a:stretch>
            <a:fillRect/>
          </a:stretch>
        </p:blipFill>
        <p:spPr bwMode="auto">
          <a:xfrm>
            <a:off x="648821" y="2435365"/>
            <a:ext cx="1515600" cy="158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44" name="ZoneTexte 143"/>
          <p:cNvSpPr txBox="1"/>
          <p:nvPr/>
        </p:nvSpPr>
        <p:spPr>
          <a:xfrm>
            <a:off x="314352" y="2421883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E2F4</a:t>
            </a:r>
          </a:p>
        </p:txBody>
      </p:sp>
      <p:sp>
        <p:nvSpPr>
          <p:cNvPr id="146" name="ZoneTexte 145"/>
          <p:cNvSpPr txBox="1"/>
          <p:nvPr/>
        </p:nvSpPr>
        <p:spPr>
          <a:xfrm>
            <a:off x="2049829" y="45626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B</a:t>
            </a:r>
          </a:p>
        </p:txBody>
      </p:sp>
      <p:graphicFrame>
        <p:nvGraphicFramePr>
          <p:cNvPr id="167" name="Graphique 166"/>
          <p:cNvGraphicFramePr/>
          <p:nvPr>
            <p:extLst>
              <p:ext uri="{D42A27DB-BD31-4B8C-83A1-F6EECF244321}">
                <p14:modId xmlns:p14="http://schemas.microsoft.com/office/powerpoint/2010/main" xmlns="" val="313060627"/>
              </p:ext>
            </p:extLst>
          </p:nvPr>
        </p:nvGraphicFramePr>
        <p:xfrm>
          <a:off x="305711" y="768499"/>
          <a:ext cx="1839589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68" name="Picture 14" descr="D:\Thèse\Projet E2F1\Expériences\Blot\Blot 4-8-14 Cinetique 2-3-4j Si E2F1 et Inhib E2F 20 microM\4-8-14-004.jpg"/>
          <p:cNvPicPr preferRelativeResize="0">
            <a:picLocks noChangeArrowheads="1"/>
          </p:cNvPicPr>
          <p:nvPr/>
        </p:nvPicPr>
        <p:blipFill>
          <a:blip r:embed="rId4" cstate="print"/>
          <a:srcRect l="9168" t="22242" r="71475" b="75815"/>
          <a:stretch>
            <a:fillRect/>
          </a:stretch>
        </p:blipFill>
        <p:spPr bwMode="auto">
          <a:xfrm>
            <a:off x="648821" y="2229542"/>
            <a:ext cx="1516807" cy="159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69" name="Picture 4" descr="C:\Users\Equipe1\Desktop\Blot 5-8-14 Cinetique 2-3-4j A375 Si E2F1 et Inhib E2F 20 microM\5-8-14-003.jpg"/>
          <p:cNvPicPr preferRelativeResize="0">
            <a:picLocks noChangeArrowheads="1"/>
          </p:cNvPicPr>
          <p:nvPr/>
        </p:nvPicPr>
        <p:blipFill>
          <a:blip r:embed="rId5" cstate="print"/>
          <a:srcRect l="54288" t="76872" r="25934" b="21206"/>
          <a:stretch>
            <a:fillRect/>
          </a:stretch>
        </p:blipFill>
        <p:spPr bwMode="auto">
          <a:xfrm>
            <a:off x="648821" y="2629561"/>
            <a:ext cx="1516807" cy="159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170" name="ZoneTexte 169"/>
          <p:cNvSpPr txBox="1"/>
          <p:nvPr/>
        </p:nvSpPr>
        <p:spPr>
          <a:xfrm>
            <a:off x="418122" y="2201067"/>
            <a:ext cx="294096" cy="147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E2F1</a:t>
            </a:r>
          </a:p>
        </p:txBody>
      </p:sp>
      <p:sp>
        <p:nvSpPr>
          <p:cNvPr id="173" name="ZoneTexte 172"/>
          <p:cNvSpPr txBox="1"/>
          <p:nvPr/>
        </p:nvSpPr>
        <p:spPr>
          <a:xfrm>
            <a:off x="358876" y="2602799"/>
            <a:ext cx="353342" cy="147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Hsp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 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ZoneTexte 173"/>
          <p:cNvSpPr txBox="1"/>
          <p:nvPr/>
        </p:nvSpPr>
        <p:spPr>
          <a:xfrm>
            <a:off x="44514" y="45626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A</a:t>
            </a:r>
          </a:p>
        </p:txBody>
      </p:sp>
      <p:sp>
        <p:nvSpPr>
          <p:cNvPr id="175" name="ZoneTexte 174"/>
          <p:cNvSpPr txBox="1"/>
          <p:nvPr/>
        </p:nvSpPr>
        <p:spPr>
          <a:xfrm>
            <a:off x="1326234" y="1482062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76" name="ZoneTexte 175"/>
          <p:cNvSpPr txBox="1"/>
          <p:nvPr/>
        </p:nvSpPr>
        <p:spPr>
          <a:xfrm>
            <a:off x="1807369" y="1697674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177" name="Rectangle 200"/>
          <p:cNvSpPr>
            <a:spLocks noChangeArrowheads="1"/>
          </p:cNvSpPr>
          <p:nvPr/>
        </p:nvSpPr>
        <p:spPr bwMode="auto">
          <a:xfrm rot="16233975">
            <a:off x="1771406" y="1283422"/>
            <a:ext cx="105024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>
                <a:latin typeface="Arial" pitchFamily="34" charset="0"/>
                <a:cs typeface="Arial" pitchFamily="34" charset="0"/>
              </a:rPr>
              <a:t>Cell</a:t>
            </a:r>
            <a:r>
              <a:rPr lang="fr-FR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number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8" name="ZoneTexte 177"/>
          <p:cNvSpPr txBox="1"/>
          <p:nvPr/>
        </p:nvSpPr>
        <p:spPr>
          <a:xfrm>
            <a:off x="1156952" y="644268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A375 </a:t>
            </a:r>
          </a:p>
        </p:txBody>
      </p:sp>
      <p:sp>
        <p:nvSpPr>
          <p:cNvPr id="179" name="Rectangle 192"/>
          <p:cNvSpPr>
            <a:spLocks noChangeArrowheads="1"/>
          </p:cNvSpPr>
          <p:nvPr/>
        </p:nvSpPr>
        <p:spPr bwMode="auto">
          <a:xfrm>
            <a:off x="3394063" y="2312496"/>
            <a:ext cx="80968" cy="80968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80" name="Rectangle 196"/>
          <p:cNvSpPr>
            <a:spLocks noChangeArrowheads="1"/>
          </p:cNvSpPr>
          <p:nvPr/>
        </p:nvSpPr>
        <p:spPr bwMode="auto">
          <a:xfrm>
            <a:off x="3432261" y="2274577"/>
            <a:ext cx="335568" cy="1478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181" name="Rectangle 193" descr="25%"/>
          <p:cNvSpPr>
            <a:spLocks noChangeArrowheads="1"/>
          </p:cNvSpPr>
          <p:nvPr/>
        </p:nvSpPr>
        <p:spPr bwMode="auto">
          <a:xfrm>
            <a:off x="3394063" y="2446206"/>
            <a:ext cx="80968" cy="8096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Rectangle 197"/>
          <p:cNvSpPr>
            <a:spLocks noChangeArrowheads="1"/>
          </p:cNvSpPr>
          <p:nvPr/>
        </p:nvSpPr>
        <p:spPr bwMode="auto">
          <a:xfrm>
            <a:off x="3432261" y="2403157"/>
            <a:ext cx="67678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42" name="Graphique 24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23550180"/>
              </p:ext>
            </p:extLst>
          </p:nvPr>
        </p:nvGraphicFramePr>
        <p:xfrm>
          <a:off x="2316943" y="5036386"/>
          <a:ext cx="2348140" cy="17333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244" name="Picture 15" descr="D:\Thèse\Projet E2F1\Expériences\Blot\Blot 6-8-14 4j Si E2F1 et inhib E2F KHN et MHN\6-8-14-001.jpg"/>
          <p:cNvPicPr preferRelativeResize="0">
            <a:picLocks noChangeArrowheads="1"/>
          </p:cNvPicPr>
          <p:nvPr/>
        </p:nvPicPr>
        <p:blipFill>
          <a:blip r:embed="rId7" cstate="print">
            <a:lum bright="20000"/>
          </a:blip>
          <a:srcRect l="10829" t="17025" r="82337" b="81844"/>
          <a:stretch>
            <a:fillRect/>
          </a:stretch>
        </p:blipFill>
        <p:spPr bwMode="auto">
          <a:xfrm>
            <a:off x="914996" y="6642238"/>
            <a:ext cx="375482" cy="1408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46" name="Picture 3" descr="D:\Thèse\Projet E2F1\Expériences\Blot\Blot 6-8-14 4j Si E2F1 et inhib E2F KHN et MHN\6-8-14-005.jpg"/>
          <p:cNvPicPr preferRelativeResize="0">
            <a:picLocks noChangeArrowheads="1"/>
          </p:cNvPicPr>
          <p:nvPr/>
        </p:nvPicPr>
        <p:blipFill>
          <a:blip r:embed="rId8" cstate="print"/>
          <a:srcRect l="44338" t="12824" r="48932" b="85525"/>
          <a:stretch>
            <a:fillRect/>
          </a:stretch>
        </p:blipFill>
        <p:spPr bwMode="auto">
          <a:xfrm>
            <a:off x="1356335" y="6836165"/>
            <a:ext cx="375482" cy="1408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247" name="Picture 14" descr="D:\Thèse\Projet E2F1\Expériences\Blot\Blot 6-8-14 4j Si E2F1 et inhib E2F KHN et MHN\6-8-14-007.jpg"/>
          <p:cNvPicPr preferRelativeResize="0">
            <a:picLocks noChangeArrowheads="1"/>
          </p:cNvPicPr>
          <p:nvPr/>
        </p:nvPicPr>
        <p:blipFill>
          <a:blip r:embed="rId9" cstate="print"/>
          <a:srcRect l="45608" t="15575" r="47987" b="82304"/>
          <a:stretch>
            <a:fillRect/>
          </a:stretch>
        </p:blipFill>
        <p:spPr bwMode="auto">
          <a:xfrm>
            <a:off x="1356335" y="6642238"/>
            <a:ext cx="375482" cy="1408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248" name="ZoneTexte 247"/>
          <p:cNvSpPr txBox="1"/>
          <p:nvPr/>
        </p:nvSpPr>
        <p:spPr>
          <a:xfrm>
            <a:off x="708815" y="6599966"/>
            <a:ext cx="259360" cy="130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E2F1</a:t>
            </a:r>
          </a:p>
        </p:txBody>
      </p:sp>
      <p:sp>
        <p:nvSpPr>
          <p:cNvPr id="249" name="ZoneTexte 248"/>
          <p:cNvSpPr txBox="1"/>
          <p:nvPr/>
        </p:nvSpPr>
        <p:spPr>
          <a:xfrm>
            <a:off x="656567" y="6795726"/>
            <a:ext cx="311609" cy="130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err="1" smtClean="0">
                <a:latin typeface="Arial" pitchFamily="34" charset="0"/>
                <a:cs typeface="Arial" pitchFamily="34" charset="0"/>
                <a:sym typeface="Webdings"/>
              </a:rPr>
              <a:t>Hsp</a:t>
            </a:r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 90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ZoneTexte 249"/>
          <p:cNvSpPr txBox="1"/>
          <p:nvPr/>
        </p:nvSpPr>
        <p:spPr>
          <a:xfrm>
            <a:off x="978694" y="6470601"/>
            <a:ext cx="245775" cy="130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NHK</a:t>
            </a:r>
          </a:p>
        </p:txBody>
      </p:sp>
      <p:sp>
        <p:nvSpPr>
          <p:cNvPr id="251" name="ZoneTexte 250"/>
          <p:cNvSpPr txBox="1"/>
          <p:nvPr/>
        </p:nvSpPr>
        <p:spPr>
          <a:xfrm>
            <a:off x="1420353" y="6470601"/>
            <a:ext cx="253091" cy="1304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NHM</a:t>
            </a:r>
          </a:p>
        </p:txBody>
      </p:sp>
      <p:grpSp>
        <p:nvGrpSpPr>
          <p:cNvPr id="252" name="Groupe 97"/>
          <p:cNvGrpSpPr/>
          <p:nvPr/>
        </p:nvGrpSpPr>
        <p:grpSpPr>
          <a:xfrm>
            <a:off x="414823" y="5013909"/>
            <a:ext cx="1550289" cy="1565932"/>
            <a:chOff x="607016" y="26894"/>
            <a:chExt cx="1863230" cy="3096301"/>
          </a:xfrm>
        </p:grpSpPr>
        <p:graphicFrame>
          <p:nvGraphicFramePr>
            <p:cNvPr id="253" name="Graphique 252"/>
            <p:cNvGraphicFramePr/>
            <p:nvPr>
              <p:extLst>
                <p:ext uri="{D42A27DB-BD31-4B8C-83A1-F6EECF244321}">
                  <p14:modId xmlns:p14="http://schemas.microsoft.com/office/powerpoint/2010/main" xmlns="" val="152910386"/>
                </p:ext>
              </p:extLst>
            </p:nvPr>
          </p:nvGraphicFramePr>
          <p:xfrm>
            <a:off x="607016" y="26894"/>
            <a:ext cx="1863230" cy="30963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254" name="Rectangle 253"/>
            <p:cNvSpPr/>
            <p:nvPr/>
          </p:nvSpPr>
          <p:spPr>
            <a:xfrm>
              <a:off x="978587" y="2619326"/>
              <a:ext cx="1333825" cy="35592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700"/>
            </a:p>
          </p:txBody>
        </p:sp>
      </p:grpSp>
      <p:sp>
        <p:nvSpPr>
          <p:cNvPr id="255" name="Rectangle 196"/>
          <p:cNvSpPr>
            <a:spLocks noChangeArrowheads="1"/>
          </p:cNvSpPr>
          <p:nvPr/>
        </p:nvSpPr>
        <p:spPr bwMode="auto">
          <a:xfrm>
            <a:off x="770166" y="6285218"/>
            <a:ext cx="489894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fr-FR" sz="7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256" name="Rectangle 197"/>
          <p:cNvSpPr>
            <a:spLocks noChangeArrowheads="1"/>
          </p:cNvSpPr>
          <p:nvPr/>
        </p:nvSpPr>
        <p:spPr bwMode="auto">
          <a:xfrm>
            <a:off x="1174823" y="6285219"/>
            <a:ext cx="74951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Rectangle 196"/>
          <p:cNvSpPr>
            <a:spLocks noChangeArrowheads="1"/>
          </p:cNvSpPr>
          <p:nvPr/>
        </p:nvSpPr>
        <p:spPr bwMode="auto">
          <a:xfrm rot="18904640">
            <a:off x="1167713" y="70448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258" name="Rectangle 197"/>
          <p:cNvSpPr>
            <a:spLocks noChangeArrowheads="1"/>
          </p:cNvSpPr>
          <p:nvPr/>
        </p:nvSpPr>
        <p:spPr bwMode="auto">
          <a:xfrm rot="18904640">
            <a:off x="1276660" y="7084471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9" name="Rectangle 196"/>
          <p:cNvSpPr>
            <a:spLocks noChangeArrowheads="1"/>
          </p:cNvSpPr>
          <p:nvPr/>
        </p:nvSpPr>
        <p:spPr bwMode="auto">
          <a:xfrm rot="18904640">
            <a:off x="713974" y="7044852"/>
            <a:ext cx="41549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DMSO</a:t>
            </a:r>
          </a:p>
        </p:txBody>
      </p:sp>
      <p:sp>
        <p:nvSpPr>
          <p:cNvPr id="260" name="Rectangle 197"/>
          <p:cNvSpPr>
            <a:spLocks noChangeArrowheads="1"/>
          </p:cNvSpPr>
          <p:nvPr/>
        </p:nvSpPr>
        <p:spPr bwMode="auto">
          <a:xfrm rot="18904640">
            <a:off x="791625" y="7084471"/>
            <a:ext cx="61106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>
                <a:latin typeface="Arial" pitchFamily="34" charset="0"/>
                <a:cs typeface="Arial" pitchFamily="34" charset="0"/>
              </a:rPr>
              <a:t>HLM006474</a:t>
            </a:r>
          </a:p>
        </p:txBody>
      </p:sp>
      <p:sp>
        <p:nvSpPr>
          <p:cNvPr id="261" name="Rectangle 200"/>
          <p:cNvSpPr>
            <a:spLocks noChangeArrowheads="1"/>
          </p:cNvSpPr>
          <p:nvPr/>
        </p:nvSpPr>
        <p:spPr bwMode="auto">
          <a:xfrm rot="16233975">
            <a:off x="-143557" y="5623903"/>
            <a:ext cx="106331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>
                <a:latin typeface="Arial" pitchFamily="34" charset="0"/>
                <a:cs typeface="Arial" pitchFamily="34" charset="0"/>
              </a:rPr>
              <a:t>Cell</a:t>
            </a:r>
            <a:r>
              <a:rPr lang="fr-FR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number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>
                <a:latin typeface="Arial" pitchFamily="34" charset="0"/>
                <a:cs typeface="Arial" pitchFamily="34" charset="0"/>
              </a:rPr>
              <a:t>(%)</a:t>
            </a:r>
          </a:p>
        </p:txBody>
      </p:sp>
      <p:pic>
        <p:nvPicPr>
          <p:cNvPr id="262" name="Picture 2" descr="C:\Users\Flo\Desktop\Thèse\Projet E2F1\Expériences\Souris E2F1--\Souris Nude A375 S et R5C3 LAbra + Inhib + PLX\A375 S Labra (1).jpg"/>
          <p:cNvPicPr>
            <a:picLocks noChangeAspect="1" noChangeArrowheads="1"/>
          </p:cNvPicPr>
          <p:nvPr/>
        </p:nvPicPr>
        <p:blipFill>
          <a:blip r:embed="rId11" cstate="print">
            <a:lum bright="20000"/>
          </a:blip>
          <a:srcRect t="37042" b="17318"/>
          <a:stretch>
            <a:fillRect/>
          </a:stretch>
        </p:blipFill>
        <p:spPr bwMode="auto">
          <a:xfrm>
            <a:off x="5372022" y="4782334"/>
            <a:ext cx="1076969" cy="368651"/>
          </a:xfrm>
          <a:prstGeom prst="rect">
            <a:avLst/>
          </a:prstGeom>
          <a:noFill/>
        </p:spPr>
      </p:pic>
      <p:pic>
        <p:nvPicPr>
          <p:cNvPr id="263" name="Picture 2" descr="C:\Users\Flo\Desktop\Thèse\Projet E2F1\Expériences\Souris E2F1--\Souris Nude A375 S et R5C3 LAbra + Inhib + PLX\A375 S Inhib (1).jpg"/>
          <p:cNvPicPr>
            <a:picLocks noChangeAspect="1" noChangeArrowheads="1"/>
          </p:cNvPicPr>
          <p:nvPr/>
        </p:nvPicPr>
        <p:blipFill>
          <a:blip r:embed="rId12" cstate="print">
            <a:lum bright="20000"/>
          </a:blip>
          <a:srcRect l="3959" t="45861" r="7065" b="19743"/>
          <a:stretch>
            <a:fillRect/>
          </a:stretch>
        </p:blipFill>
        <p:spPr bwMode="auto">
          <a:xfrm>
            <a:off x="5366291" y="5184579"/>
            <a:ext cx="1072572" cy="310972"/>
          </a:xfrm>
          <a:prstGeom prst="rect">
            <a:avLst/>
          </a:prstGeom>
          <a:noFill/>
        </p:spPr>
      </p:pic>
      <p:sp>
        <p:nvSpPr>
          <p:cNvPr id="264" name="Rectangle 263"/>
          <p:cNvSpPr>
            <a:spLocks noChangeArrowheads="1"/>
          </p:cNvSpPr>
          <p:nvPr/>
        </p:nvSpPr>
        <p:spPr bwMode="auto">
          <a:xfrm>
            <a:off x="6047535" y="4987208"/>
            <a:ext cx="457177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912813"/>
            <a:r>
              <a:rPr lang="fr-FR" altLang="en-US" sz="700" b="1" dirty="0" err="1" smtClean="0">
                <a:cs typeface="Arial" pitchFamily="34" charset="0"/>
              </a:rPr>
              <a:t>Vehicle</a:t>
            </a:r>
            <a:endParaRPr lang="fr-FR" altLang="en-US" sz="700" b="1" dirty="0">
              <a:cs typeface="Arial" pitchFamily="34" charset="0"/>
            </a:endParaRPr>
          </a:p>
        </p:txBody>
      </p:sp>
      <p:sp>
        <p:nvSpPr>
          <p:cNvPr id="265" name="Rectangle 264"/>
          <p:cNvSpPr>
            <a:spLocks noChangeArrowheads="1"/>
          </p:cNvSpPr>
          <p:nvPr/>
        </p:nvSpPr>
        <p:spPr bwMode="auto">
          <a:xfrm>
            <a:off x="5880230" y="5351321"/>
            <a:ext cx="62709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912813"/>
            <a:r>
              <a:rPr lang="fr-FR" altLang="en-US" sz="700" b="1" dirty="0" smtClean="0">
                <a:cs typeface="Arial" pitchFamily="34" charset="0"/>
              </a:rPr>
              <a:t>HLM006474</a:t>
            </a:r>
            <a:endParaRPr lang="fr-FR" altLang="en-US" sz="700" b="1" dirty="0">
              <a:cs typeface="Arial" pitchFamily="34" charset="0"/>
            </a:endParaRPr>
          </a:p>
        </p:txBody>
      </p:sp>
      <p:sp>
        <p:nvSpPr>
          <p:cNvPr id="266" name="Rectangle 265"/>
          <p:cNvSpPr>
            <a:spLocks noChangeArrowheads="1"/>
          </p:cNvSpPr>
          <p:nvPr/>
        </p:nvSpPr>
        <p:spPr bwMode="auto">
          <a:xfrm>
            <a:off x="3548061" y="6739896"/>
            <a:ext cx="239405" cy="1203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912813"/>
            <a:r>
              <a:rPr lang="fr-FR" altLang="en-US" sz="700" b="1" dirty="0" err="1" smtClean="0">
                <a:latin typeface="Arial" pitchFamily="34" charset="0"/>
                <a:cs typeface="Arial" pitchFamily="34" charset="0"/>
              </a:rPr>
              <a:t>Days</a:t>
            </a:r>
            <a:endParaRPr lang="fr-FR" altLang="en-US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7" name="Rectangle 200"/>
          <p:cNvSpPr>
            <a:spLocks noChangeArrowheads="1"/>
          </p:cNvSpPr>
          <p:nvPr/>
        </p:nvSpPr>
        <p:spPr bwMode="auto">
          <a:xfrm rot="16233975">
            <a:off x="1422205" y="5588854"/>
            <a:ext cx="171663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Tumor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volume (mm</a:t>
            </a:r>
            <a:r>
              <a:rPr lang="fr-FR" sz="800" b="1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8" name="Rectangle 200"/>
          <p:cNvSpPr>
            <a:spLocks noChangeArrowheads="1"/>
          </p:cNvSpPr>
          <p:nvPr/>
        </p:nvSpPr>
        <p:spPr bwMode="auto">
          <a:xfrm rot="16233975">
            <a:off x="4383820" y="5747099"/>
            <a:ext cx="117828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Tumor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weight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g) 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ZoneTexte 268"/>
          <p:cNvSpPr txBox="1"/>
          <p:nvPr/>
        </p:nvSpPr>
        <p:spPr>
          <a:xfrm>
            <a:off x="55735" y="4844553"/>
            <a:ext cx="30168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F</a:t>
            </a:r>
          </a:p>
        </p:txBody>
      </p:sp>
      <p:sp>
        <p:nvSpPr>
          <p:cNvPr id="270" name="ZoneTexte 269"/>
          <p:cNvSpPr txBox="1"/>
          <p:nvPr/>
        </p:nvSpPr>
        <p:spPr>
          <a:xfrm>
            <a:off x="4688131" y="4844553"/>
            <a:ext cx="33374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H</a:t>
            </a:r>
          </a:p>
        </p:txBody>
      </p:sp>
      <p:sp>
        <p:nvSpPr>
          <p:cNvPr id="271" name="ZoneTexte 270"/>
          <p:cNvSpPr txBox="1"/>
          <p:nvPr/>
        </p:nvSpPr>
        <p:spPr>
          <a:xfrm>
            <a:off x="3109436" y="6364661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272" name="ZoneTexte 271"/>
          <p:cNvSpPr txBox="1"/>
          <p:nvPr/>
        </p:nvSpPr>
        <p:spPr>
          <a:xfrm>
            <a:off x="5842613" y="6100626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273" name="ZoneTexte 272"/>
          <p:cNvSpPr txBox="1"/>
          <p:nvPr/>
        </p:nvSpPr>
        <p:spPr>
          <a:xfrm>
            <a:off x="3281453" y="6338191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300" name="ZoneTexte 299"/>
          <p:cNvSpPr txBox="1"/>
          <p:nvPr/>
        </p:nvSpPr>
        <p:spPr>
          <a:xfrm>
            <a:off x="3460549" y="6333047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301" name="ZoneTexte 300"/>
          <p:cNvSpPr txBox="1"/>
          <p:nvPr/>
        </p:nvSpPr>
        <p:spPr>
          <a:xfrm>
            <a:off x="3641192" y="6326105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302" name="ZoneTexte 301"/>
          <p:cNvSpPr txBox="1"/>
          <p:nvPr/>
        </p:nvSpPr>
        <p:spPr>
          <a:xfrm>
            <a:off x="3791556" y="6322759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03" name="ZoneTexte 302"/>
          <p:cNvSpPr txBox="1"/>
          <p:nvPr/>
        </p:nvSpPr>
        <p:spPr>
          <a:xfrm>
            <a:off x="3953216" y="6283589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04" name="ZoneTexte 303"/>
          <p:cNvSpPr txBox="1"/>
          <p:nvPr/>
        </p:nvSpPr>
        <p:spPr>
          <a:xfrm>
            <a:off x="4122760" y="6246217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05" name="ZoneTexte 304"/>
          <p:cNvSpPr txBox="1"/>
          <p:nvPr/>
        </p:nvSpPr>
        <p:spPr>
          <a:xfrm>
            <a:off x="4301856" y="6200219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06" name="Line 311"/>
          <p:cNvSpPr>
            <a:spLocks noChangeShapeType="1"/>
          </p:cNvSpPr>
          <p:nvPr/>
        </p:nvSpPr>
        <p:spPr bwMode="auto">
          <a:xfrm flipV="1">
            <a:off x="2854211" y="6715268"/>
            <a:ext cx="1584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07" name="Graphique 30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437687501"/>
              </p:ext>
            </p:extLst>
          </p:nvPr>
        </p:nvGraphicFramePr>
        <p:xfrm>
          <a:off x="4990640" y="5325630"/>
          <a:ext cx="1366500" cy="1328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308" name="Rectangle 196"/>
          <p:cNvSpPr>
            <a:spLocks noChangeArrowheads="1"/>
          </p:cNvSpPr>
          <p:nvPr/>
        </p:nvSpPr>
        <p:spPr bwMode="auto">
          <a:xfrm>
            <a:off x="3076965" y="5286680"/>
            <a:ext cx="49885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err="1" smtClean="0">
                <a:latin typeface="Arial" pitchFamily="34" charset="0"/>
                <a:cs typeface="Arial" pitchFamily="34" charset="0"/>
              </a:rPr>
              <a:t>Vehicle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Rectangle 197"/>
          <p:cNvSpPr>
            <a:spLocks noChangeArrowheads="1"/>
          </p:cNvSpPr>
          <p:nvPr/>
        </p:nvSpPr>
        <p:spPr bwMode="auto">
          <a:xfrm>
            <a:off x="3076965" y="5441277"/>
            <a:ext cx="67678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0" name="Rectangle 309"/>
          <p:cNvSpPr/>
          <p:nvPr/>
        </p:nvSpPr>
        <p:spPr>
          <a:xfrm>
            <a:off x="5345257" y="6383290"/>
            <a:ext cx="903828" cy="2461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900"/>
          </a:p>
        </p:txBody>
      </p:sp>
      <p:sp>
        <p:nvSpPr>
          <p:cNvPr id="311" name="Rectangle 310"/>
          <p:cNvSpPr>
            <a:spLocks noChangeArrowheads="1"/>
          </p:cNvSpPr>
          <p:nvPr/>
        </p:nvSpPr>
        <p:spPr bwMode="auto">
          <a:xfrm>
            <a:off x="5268890" y="6344062"/>
            <a:ext cx="49725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912813"/>
            <a:r>
              <a:rPr lang="fr-FR" altLang="en-US" sz="800" b="1" dirty="0" err="1" smtClean="0">
                <a:cs typeface="Arial" pitchFamily="34" charset="0"/>
              </a:rPr>
              <a:t>Vehicle</a:t>
            </a:r>
            <a:endParaRPr lang="fr-FR" altLang="en-US" sz="800" b="1" dirty="0">
              <a:cs typeface="Arial" pitchFamily="34" charset="0"/>
            </a:endParaRPr>
          </a:p>
        </p:txBody>
      </p:sp>
      <p:sp>
        <p:nvSpPr>
          <p:cNvPr id="312" name="Rectangle 311"/>
          <p:cNvSpPr>
            <a:spLocks noChangeArrowheads="1"/>
          </p:cNvSpPr>
          <p:nvPr/>
        </p:nvSpPr>
        <p:spPr bwMode="auto">
          <a:xfrm>
            <a:off x="5659384" y="6344062"/>
            <a:ext cx="6896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912813"/>
            <a:r>
              <a:rPr lang="fr-FR" altLang="en-US" sz="800" b="1" dirty="0" smtClean="0">
                <a:cs typeface="Arial" pitchFamily="34" charset="0"/>
              </a:rPr>
              <a:t>HLM006474</a:t>
            </a:r>
            <a:endParaRPr lang="fr-FR" altLang="en-US" sz="800" b="1" dirty="0">
              <a:cs typeface="Arial" pitchFamily="34" charset="0"/>
            </a:endParaRPr>
          </a:p>
        </p:txBody>
      </p:sp>
      <p:sp>
        <p:nvSpPr>
          <p:cNvPr id="313" name="ZoneTexte 312"/>
          <p:cNvSpPr txBox="1"/>
          <p:nvPr/>
        </p:nvSpPr>
        <p:spPr>
          <a:xfrm>
            <a:off x="2041477" y="4844553"/>
            <a:ext cx="33374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G</a:t>
            </a:r>
          </a:p>
        </p:txBody>
      </p:sp>
      <p:cxnSp>
        <p:nvCxnSpPr>
          <p:cNvPr id="314" name="Connecteur droit 313"/>
          <p:cNvCxnSpPr/>
          <p:nvPr/>
        </p:nvCxnSpPr>
        <p:spPr>
          <a:xfrm>
            <a:off x="2973368" y="5390204"/>
            <a:ext cx="144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Connecteur droit 314"/>
          <p:cNvCxnSpPr/>
          <p:nvPr/>
        </p:nvCxnSpPr>
        <p:spPr>
          <a:xfrm>
            <a:off x="2973368" y="5542604"/>
            <a:ext cx="144000" cy="0"/>
          </a:xfrm>
          <a:prstGeom prst="line">
            <a:avLst/>
          </a:prstGeom>
          <a:ln w="285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6" name="Rectangle 194" descr="Diagonales larges vers le haut"/>
          <p:cNvSpPr>
            <a:spLocks noChangeArrowheads="1"/>
          </p:cNvSpPr>
          <p:nvPr/>
        </p:nvSpPr>
        <p:spPr bwMode="auto">
          <a:xfrm>
            <a:off x="1624117" y="4970972"/>
            <a:ext cx="80968" cy="80968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Rectangle 198"/>
          <p:cNvSpPr>
            <a:spLocks noChangeArrowheads="1"/>
          </p:cNvSpPr>
          <p:nvPr/>
        </p:nvSpPr>
        <p:spPr bwMode="auto">
          <a:xfrm>
            <a:off x="1662315" y="4919085"/>
            <a:ext cx="377026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NHK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8" name="Rectangle 195" descr="noir)"/>
          <p:cNvSpPr>
            <a:spLocks noChangeArrowheads="1"/>
          </p:cNvSpPr>
          <p:nvPr/>
        </p:nvSpPr>
        <p:spPr bwMode="auto">
          <a:xfrm>
            <a:off x="1624117" y="5106903"/>
            <a:ext cx="80968" cy="80968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fr-FR" sz="700">
              <a:latin typeface="Arial" pitchFamily="34" charset="0"/>
              <a:cs typeface="Arial" pitchFamily="34" charset="0"/>
            </a:endParaRPr>
          </a:p>
        </p:txBody>
      </p:sp>
      <p:sp>
        <p:nvSpPr>
          <p:cNvPr id="319" name="Rectangle 199"/>
          <p:cNvSpPr>
            <a:spLocks noChangeArrowheads="1"/>
          </p:cNvSpPr>
          <p:nvPr/>
        </p:nvSpPr>
        <p:spPr bwMode="auto">
          <a:xfrm>
            <a:off x="1662315" y="5051224"/>
            <a:ext cx="388248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NHM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1" name="Rectangle 320"/>
          <p:cNvSpPr/>
          <p:nvPr/>
        </p:nvSpPr>
        <p:spPr>
          <a:xfrm>
            <a:off x="2903744" y="5309836"/>
            <a:ext cx="883721" cy="31828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22" name="Connecteur droit avec flèche 321"/>
          <p:cNvCxnSpPr/>
          <p:nvPr/>
        </p:nvCxnSpPr>
        <p:spPr>
          <a:xfrm>
            <a:off x="3061524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Rectangle 322"/>
          <p:cNvSpPr>
            <a:spLocks noChangeArrowheads="1"/>
          </p:cNvSpPr>
          <p:nvPr/>
        </p:nvSpPr>
        <p:spPr bwMode="auto">
          <a:xfrm>
            <a:off x="2739880" y="5830136"/>
            <a:ext cx="63419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defTabSz="912813"/>
            <a:r>
              <a:rPr lang="fr-FR" altLang="en-US" sz="800" b="1" dirty="0" smtClean="0">
                <a:latin typeface="Arial" pitchFamily="34" charset="0"/>
                <a:cs typeface="Arial" pitchFamily="34" charset="0"/>
              </a:rPr>
              <a:t>Injection</a:t>
            </a:r>
          </a:p>
        </p:txBody>
      </p:sp>
      <p:cxnSp>
        <p:nvCxnSpPr>
          <p:cNvPr id="324" name="Connecteur droit avec flèche 323"/>
          <p:cNvCxnSpPr/>
          <p:nvPr/>
        </p:nvCxnSpPr>
        <p:spPr>
          <a:xfrm>
            <a:off x="2795049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5" name="Connecteur droit avec flèche 324"/>
          <p:cNvCxnSpPr/>
          <p:nvPr/>
        </p:nvCxnSpPr>
        <p:spPr>
          <a:xfrm>
            <a:off x="3215799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6" name="Connecteur droit avec flèche 325"/>
          <p:cNvCxnSpPr/>
          <p:nvPr/>
        </p:nvCxnSpPr>
        <p:spPr>
          <a:xfrm>
            <a:off x="2882004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Connecteur droit avec flèche 326"/>
          <p:cNvCxnSpPr/>
          <p:nvPr/>
        </p:nvCxnSpPr>
        <p:spPr>
          <a:xfrm>
            <a:off x="2971764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Connecteur droit avec flèche 327"/>
          <p:cNvCxnSpPr/>
          <p:nvPr/>
        </p:nvCxnSpPr>
        <p:spPr>
          <a:xfrm>
            <a:off x="3333609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9" name="Connecteur droit avec flèche 328"/>
          <p:cNvCxnSpPr/>
          <p:nvPr/>
        </p:nvCxnSpPr>
        <p:spPr>
          <a:xfrm>
            <a:off x="3156894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0" name="Connecteur droit avec flèche 329"/>
          <p:cNvCxnSpPr/>
          <p:nvPr/>
        </p:nvCxnSpPr>
        <p:spPr>
          <a:xfrm>
            <a:off x="3274704" y="6026473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31" name="Graphique 3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991883602"/>
              </p:ext>
            </p:extLst>
          </p:nvPr>
        </p:nvGraphicFramePr>
        <p:xfrm>
          <a:off x="2302513" y="679399"/>
          <a:ext cx="2627974" cy="1641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332" name="ZoneTexte 331"/>
          <p:cNvSpPr txBox="1"/>
          <p:nvPr/>
        </p:nvSpPr>
        <p:spPr>
          <a:xfrm>
            <a:off x="2791223" y="1301427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33" name="ZoneTexte 332"/>
          <p:cNvSpPr txBox="1"/>
          <p:nvPr/>
        </p:nvSpPr>
        <p:spPr>
          <a:xfrm>
            <a:off x="3207596" y="1639641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34" name="ZoneTexte 333"/>
          <p:cNvSpPr txBox="1"/>
          <p:nvPr/>
        </p:nvSpPr>
        <p:spPr>
          <a:xfrm>
            <a:off x="4072895" y="1703049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35" name="ZoneTexte 334"/>
          <p:cNvSpPr txBox="1"/>
          <p:nvPr/>
        </p:nvSpPr>
        <p:spPr>
          <a:xfrm>
            <a:off x="4522258" y="1490863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336" name="ZoneTexte 335"/>
          <p:cNvSpPr txBox="1"/>
          <p:nvPr/>
        </p:nvSpPr>
        <p:spPr>
          <a:xfrm>
            <a:off x="3640471" y="1463171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***</a:t>
            </a:r>
          </a:p>
        </p:txBody>
      </p:sp>
      <p:sp>
        <p:nvSpPr>
          <p:cNvPr id="337" name="Rectangle 200"/>
          <p:cNvSpPr>
            <a:spLocks noChangeArrowheads="1"/>
          </p:cNvSpPr>
          <p:nvPr/>
        </p:nvSpPr>
        <p:spPr bwMode="auto">
          <a:xfrm rot="16233975">
            <a:off x="-358754" y="1283422"/>
            <a:ext cx="105024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>
                <a:latin typeface="Arial" pitchFamily="34" charset="0"/>
                <a:cs typeface="Arial" pitchFamily="34" charset="0"/>
              </a:rPr>
              <a:t>Cell</a:t>
            </a:r>
            <a:r>
              <a:rPr lang="fr-FR" sz="800" b="1" dirty="0">
                <a:latin typeface="Arial" pitchFamily="34" charset="0"/>
                <a:cs typeface="Arial" pitchFamily="34" charset="0"/>
              </a:rPr>
              <a:t> 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number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(%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685710" y="2075160"/>
            <a:ext cx="2593075" cy="1910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8" name="Rectangle 196"/>
          <p:cNvSpPr>
            <a:spLocks noChangeArrowheads="1"/>
          </p:cNvSpPr>
          <p:nvPr/>
        </p:nvSpPr>
        <p:spPr bwMode="auto">
          <a:xfrm>
            <a:off x="3027692" y="2021027"/>
            <a:ext cx="514885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Mel-5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9" name="ZoneTexte 338"/>
          <p:cNvSpPr txBox="1"/>
          <p:nvPr/>
        </p:nvSpPr>
        <p:spPr>
          <a:xfrm>
            <a:off x="4332917" y="2021027"/>
            <a:ext cx="5036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10.05</a:t>
            </a:r>
          </a:p>
        </p:txBody>
      </p:sp>
      <p:sp>
        <p:nvSpPr>
          <p:cNvPr id="340" name="ZoneTexte 339"/>
          <p:cNvSpPr txBox="1"/>
          <p:nvPr/>
        </p:nvSpPr>
        <p:spPr>
          <a:xfrm>
            <a:off x="3889851" y="2021027"/>
            <a:ext cx="5293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10.01 </a:t>
            </a:r>
          </a:p>
        </p:txBody>
      </p:sp>
      <p:sp>
        <p:nvSpPr>
          <p:cNvPr id="341" name="ZoneTexte 340"/>
          <p:cNvSpPr txBox="1"/>
          <p:nvPr/>
        </p:nvSpPr>
        <p:spPr>
          <a:xfrm>
            <a:off x="3457114" y="2021027"/>
            <a:ext cx="5293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C-09.01 </a:t>
            </a:r>
          </a:p>
        </p:txBody>
      </p:sp>
      <p:sp>
        <p:nvSpPr>
          <p:cNvPr id="343" name="Rectangle 196"/>
          <p:cNvSpPr>
            <a:spLocks noChangeArrowheads="1"/>
          </p:cNvSpPr>
          <p:nvPr/>
        </p:nvSpPr>
        <p:spPr bwMode="auto">
          <a:xfrm>
            <a:off x="2604187" y="2021027"/>
            <a:ext cx="51809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fr-FR" sz="700" b="1" dirty="0" smtClean="0">
                <a:latin typeface="Arial" pitchFamily="34" charset="0"/>
                <a:cs typeface="Arial" pitchFamily="34" charset="0"/>
              </a:rPr>
              <a:t>1205 Lu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7" name="ZoneTexte 396"/>
          <p:cNvSpPr txBox="1"/>
          <p:nvPr/>
        </p:nvSpPr>
        <p:spPr>
          <a:xfrm>
            <a:off x="4655120" y="6984254"/>
            <a:ext cx="4523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Hsp90</a:t>
            </a:r>
          </a:p>
        </p:txBody>
      </p:sp>
      <p:sp>
        <p:nvSpPr>
          <p:cNvPr id="398" name="ZoneTexte 397"/>
          <p:cNvSpPr txBox="1"/>
          <p:nvPr/>
        </p:nvSpPr>
        <p:spPr>
          <a:xfrm>
            <a:off x="4709622" y="6614065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E2F4</a:t>
            </a:r>
          </a:p>
        </p:txBody>
      </p:sp>
      <p:pic>
        <p:nvPicPr>
          <p:cNvPr id="399" name="Picture 2" descr="C:\Users\Flo\Desktop\Thèse\Projet E2F1\Expériences\Souris E2F1--\Souris Nude A375 S et R5C3 LAbra + Inhib + PLX\Blot 27-2-15 Tumeur Labra Inhib et PLX\27-2-15007.jpg"/>
          <p:cNvPicPr preferRelativeResize="0">
            <a:picLocks noChangeArrowheads="1"/>
          </p:cNvPicPr>
          <p:nvPr/>
        </p:nvPicPr>
        <p:blipFill>
          <a:blip r:embed="rId15" cstate="print">
            <a:lum bright="20000"/>
          </a:blip>
          <a:srcRect l="5032" t="49779" r="70021" b="47123"/>
          <a:stretch>
            <a:fillRect/>
          </a:stretch>
        </p:blipFill>
        <p:spPr bwMode="auto">
          <a:xfrm>
            <a:off x="5043984" y="6840675"/>
            <a:ext cx="1440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400" name="Picture 3" descr="C:\Users\Flo\Desktop\Thèse\Projet E2F1\Expériences\Souris E2F1--\Souris Nude A375 S et R5C3 LAbra + Inhib + PLX\Blot 27-2-15 Tumeur Labra Inhib et PLX\27-2-15008.jpg"/>
          <p:cNvPicPr preferRelativeResize="0">
            <a:picLocks noChangeArrowheads="1"/>
          </p:cNvPicPr>
          <p:nvPr/>
        </p:nvPicPr>
        <p:blipFill>
          <a:blip r:embed="rId16" cstate="print"/>
          <a:srcRect l="55114" t="58709" r="20462" b="39246"/>
          <a:stretch>
            <a:fillRect/>
          </a:stretch>
        </p:blipFill>
        <p:spPr bwMode="auto">
          <a:xfrm>
            <a:off x="5043984" y="7031984"/>
            <a:ext cx="1440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01" name="ZoneTexte 400"/>
          <p:cNvSpPr txBox="1"/>
          <p:nvPr/>
        </p:nvSpPr>
        <p:spPr>
          <a:xfrm>
            <a:off x="5175451" y="7357587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Vehicle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2" name="ZoneTexte 401"/>
          <p:cNvSpPr txBox="1"/>
          <p:nvPr/>
        </p:nvSpPr>
        <p:spPr>
          <a:xfrm>
            <a:off x="5207916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2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3" name="ZoneTexte 402"/>
          <p:cNvSpPr txBox="1"/>
          <p:nvPr/>
        </p:nvSpPr>
        <p:spPr>
          <a:xfrm>
            <a:off x="5013884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1</a:t>
            </a:r>
          </a:p>
        </p:txBody>
      </p:sp>
      <p:sp>
        <p:nvSpPr>
          <p:cNvPr id="404" name="ZoneTexte 403"/>
          <p:cNvSpPr txBox="1"/>
          <p:nvPr/>
        </p:nvSpPr>
        <p:spPr>
          <a:xfrm>
            <a:off x="5579029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5" name="ZoneTexte 404"/>
          <p:cNvSpPr txBox="1"/>
          <p:nvPr/>
        </p:nvSpPr>
        <p:spPr>
          <a:xfrm>
            <a:off x="5388818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3</a:t>
            </a:r>
          </a:p>
        </p:txBody>
      </p:sp>
      <p:cxnSp>
        <p:nvCxnSpPr>
          <p:cNvPr id="406" name="Connecteur droit 405"/>
          <p:cNvCxnSpPr>
            <a:stCxn id="409" idx="2"/>
            <a:endCxn id="410" idx="2"/>
          </p:cNvCxnSpPr>
          <p:nvPr/>
        </p:nvCxnSpPr>
        <p:spPr>
          <a:xfrm>
            <a:off x="5868726" y="7343776"/>
            <a:ext cx="5406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ZoneTexte 406"/>
          <p:cNvSpPr txBox="1"/>
          <p:nvPr/>
        </p:nvSpPr>
        <p:spPr>
          <a:xfrm>
            <a:off x="5784630" y="7355612"/>
            <a:ext cx="7227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HLM006474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8" name="ZoneTexte 407"/>
          <p:cNvSpPr txBox="1"/>
          <p:nvPr/>
        </p:nvSpPr>
        <p:spPr>
          <a:xfrm>
            <a:off x="5928199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6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9" name="ZoneTexte 408"/>
          <p:cNvSpPr txBox="1"/>
          <p:nvPr/>
        </p:nvSpPr>
        <p:spPr>
          <a:xfrm>
            <a:off x="5754752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5</a:t>
            </a:r>
          </a:p>
        </p:txBody>
      </p:sp>
      <p:sp>
        <p:nvSpPr>
          <p:cNvPr id="410" name="ZoneTexte 409"/>
          <p:cNvSpPr txBox="1"/>
          <p:nvPr/>
        </p:nvSpPr>
        <p:spPr>
          <a:xfrm>
            <a:off x="6295379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1" name="ZoneTexte 410"/>
          <p:cNvSpPr txBox="1"/>
          <p:nvPr/>
        </p:nvSpPr>
        <p:spPr>
          <a:xfrm>
            <a:off x="6115164" y="7159110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600" b="1" dirty="0" smtClean="0">
                <a:latin typeface="Arial" pitchFamily="34" charset="0"/>
                <a:cs typeface="Arial" pitchFamily="34" charset="0"/>
              </a:rPr>
              <a:t>7</a:t>
            </a:r>
          </a:p>
        </p:txBody>
      </p:sp>
      <p:cxnSp>
        <p:nvCxnSpPr>
          <p:cNvPr id="412" name="Connecteur droit 411"/>
          <p:cNvCxnSpPr>
            <a:stCxn id="403" idx="2"/>
            <a:endCxn id="404" idx="2"/>
          </p:cNvCxnSpPr>
          <p:nvPr/>
        </p:nvCxnSpPr>
        <p:spPr>
          <a:xfrm>
            <a:off x="5127858" y="7343776"/>
            <a:ext cx="56514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3" name="Picture 5" descr="C:\Users\Flo\Desktop\Thèse\Projet E2F1\Expériences\Souris E2F1--\Souris Nude A375 S et R5C3 LAbra + Inhib + PLX\Blot 27-2-15 Tumeur Labra Inhib et PLX\27-2-15006.jpg"/>
          <p:cNvPicPr preferRelativeResize="0">
            <a:picLocks noChangeArrowheads="1"/>
          </p:cNvPicPr>
          <p:nvPr/>
        </p:nvPicPr>
        <p:blipFill rotWithShape="1">
          <a:blip r:embed="rId17" cstate="print"/>
          <a:srcRect l="4244" t="67376" r="70760" b="30624"/>
          <a:stretch/>
        </p:blipFill>
        <p:spPr bwMode="auto">
          <a:xfrm>
            <a:off x="5043984" y="6642757"/>
            <a:ext cx="1440000" cy="14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414" name="ZoneTexte 413"/>
          <p:cNvSpPr txBox="1"/>
          <p:nvPr/>
        </p:nvSpPr>
        <p:spPr>
          <a:xfrm>
            <a:off x="4709622" y="6795040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700" b="1" dirty="0" smtClean="0">
                <a:latin typeface="Arial" pitchFamily="34" charset="0"/>
                <a:cs typeface="Arial" pitchFamily="34" charset="0"/>
                <a:sym typeface="Webdings"/>
              </a:rPr>
              <a:t>E2F1</a:t>
            </a:r>
          </a:p>
        </p:txBody>
      </p:sp>
      <p:sp>
        <p:nvSpPr>
          <p:cNvPr id="161" name="ZoneTexte 160"/>
          <p:cNvSpPr txBox="1"/>
          <p:nvPr/>
        </p:nvSpPr>
        <p:spPr>
          <a:xfrm>
            <a:off x="4781030" y="456267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smtClean="0">
                <a:latin typeface="Arial" pitchFamily="34" charset="0"/>
                <a:cs typeface="Arial" pitchFamily="34" charset="0"/>
                <a:sym typeface="Webdings"/>
              </a:rPr>
              <a:t>D</a:t>
            </a:r>
            <a:endParaRPr lang="fr-FR" sz="1500" b="1" dirty="0" smtClean="0">
              <a:latin typeface="Arial" pitchFamily="34" charset="0"/>
              <a:cs typeface="Arial" pitchFamily="34" charset="0"/>
              <a:sym typeface="Webdings"/>
            </a:endParaRPr>
          </a:p>
        </p:txBody>
      </p:sp>
      <p:pic>
        <p:nvPicPr>
          <p:cNvPr id="163" name="Picture 5" descr="C:\Users\Florian\Desktop\These Flo\Thèse Bis\Projet E2F1\Expériences\Blot\Blot 6-8-14 4j Si E2F1 et inhib E2F KHN et MHN\6-8-14-006.jpg"/>
          <p:cNvPicPr preferRelativeResize="0">
            <a:picLocks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0702" t="11495" r="82615" b="86470"/>
          <a:stretch/>
        </p:blipFill>
        <p:spPr bwMode="auto">
          <a:xfrm>
            <a:off x="914996" y="6836571"/>
            <a:ext cx="374400" cy="1404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159" name="ZoneTexte 158"/>
          <p:cNvSpPr txBox="1"/>
          <p:nvPr/>
        </p:nvSpPr>
        <p:spPr>
          <a:xfrm>
            <a:off x="30660" y="2725823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C</a:t>
            </a:r>
          </a:p>
        </p:txBody>
      </p:sp>
      <p:graphicFrame>
        <p:nvGraphicFramePr>
          <p:cNvPr id="198" name="Graphique 197"/>
          <p:cNvGraphicFramePr/>
          <p:nvPr>
            <p:extLst>
              <p:ext uri="{D42A27DB-BD31-4B8C-83A1-F6EECF244321}">
                <p14:modId xmlns:p14="http://schemas.microsoft.com/office/powerpoint/2010/main" xmlns="" val="735899473"/>
              </p:ext>
            </p:extLst>
          </p:nvPr>
        </p:nvGraphicFramePr>
        <p:xfrm>
          <a:off x="309408" y="2922532"/>
          <a:ext cx="3871582" cy="18407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pSp>
        <p:nvGrpSpPr>
          <p:cNvPr id="238" name="Groupe 237"/>
          <p:cNvGrpSpPr/>
          <p:nvPr/>
        </p:nvGrpSpPr>
        <p:grpSpPr>
          <a:xfrm>
            <a:off x="5202492" y="1179376"/>
            <a:ext cx="920502" cy="1040632"/>
            <a:chOff x="4955982" y="1179376"/>
            <a:chExt cx="920502" cy="1040632"/>
          </a:xfrm>
        </p:grpSpPr>
        <p:pic>
          <p:nvPicPr>
            <p:cNvPr id="239" name="Picture 8" descr="C:\Users\Florian\Desktop\These Flo\Thèse Bis\Projet E2F1\Expériences\Blot\Blot 5-12-14 Cinetique 4j A375 Si E2F1 3 et 4\5-12-14-003.jpg"/>
            <p:cNvPicPr preferRelativeResize="0">
              <a:picLocks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7555" t="42745" r="32386" b="52948"/>
            <a:stretch/>
          </p:blipFill>
          <p:spPr bwMode="auto">
            <a:xfrm>
              <a:off x="5371250" y="1204124"/>
              <a:ext cx="485990" cy="1420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3" name="Picture 3" descr="C:\Users\Flo\Desktop\Thèse\Projet E2F1\Expériences\Blot\Blot 5-12-14 Cinetique 4j A375 Si E2F1 3 et 4\8-12-14-001.jpg"/>
            <p:cNvPicPr preferRelativeResize="0">
              <a:picLocks noChangeArrowheads="1"/>
            </p:cNvPicPr>
            <p:nvPr/>
          </p:nvPicPr>
          <p:blipFill>
            <a:blip r:embed="rId21" cstate="print"/>
            <a:srcRect l="16146" t="55457" r="67122" b="35320"/>
            <a:stretch>
              <a:fillRect/>
            </a:stretch>
          </p:blipFill>
          <p:spPr bwMode="auto">
            <a:xfrm>
              <a:off x="5371250" y="1569618"/>
              <a:ext cx="480910" cy="1372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274" name="Rectangle 196"/>
            <p:cNvSpPr>
              <a:spLocks noChangeArrowheads="1"/>
            </p:cNvSpPr>
            <p:nvPr/>
          </p:nvSpPr>
          <p:spPr bwMode="auto">
            <a:xfrm rot="16200000">
              <a:off x="5294107" y="1743596"/>
              <a:ext cx="35137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fr-FR" sz="600" b="1" dirty="0" err="1" smtClean="0">
                  <a:latin typeface="Arial" pitchFamily="34" charset="0"/>
                  <a:cs typeface="Arial" pitchFamily="34" charset="0"/>
                </a:rPr>
                <a:t>siCtl</a:t>
              </a:r>
              <a:endParaRPr lang="fr-FR" sz="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Rectangle 197"/>
            <p:cNvSpPr>
              <a:spLocks noChangeArrowheads="1"/>
            </p:cNvSpPr>
            <p:nvPr/>
          </p:nvSpPr>
          <p:spPr bwMode="auto">
            <a:xfrm rot="16200000">
              <a:off x="5359803" y="1847791"/>
              <a:ext cx="55976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fr-FR" sz="600" b="1" dirty="0" smtClean="0">
                  <a:latin typeface="Arial" pitchFamily="34" charset="0"/>
                  <a:cs typeface="Arial" pitchFamily="34" charset="0"/>
                </a:rPr>
                <a:t>siE2F1 ≠ 1</a:t>
              </a:r>
            </a:p>
          </p:txBody>
        </p:sp>
        <p:sp>
          <p:nvSpPr>
            <p:cNvPr id="276" name="Rectangle 196"/>
            <p:cNvSpPr>
              <a:spLocks noChangeArrowheads="1"/>
            </p:cNvSpPr>
            <p:nvPr/>
          </p:nvSpPr>
          <p:spPr bwMode="auto">
            <a:xfrm rot="16200000">
              <a:off x="5504266" y="1847791"/>
              <a:ext cx="55976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fr-FR" sz="600" b="1" dirty="0" smtClean="0">
                  <a:latin typeface="Arial" pitchFamily="34" charset="0"/>
                  <a:cs typeface="Arial" pitchFamily="34" charset="0"/>
                </a:rPr>
                <a:t>siE2F1 ≠ 2</a:t>
              </a:r>
            </a:p>
          </p:txBody>
        </p:sp>
        <p:sp>
          <p:nvSpPr>
            <p:cNvPr id="277" name="ZoneTexte 276"/>
            <p:cNvSpPr txBox="1"/>
            <p:nvPr/>
          </p:nvSpPr>
          <p:spPr>
            <a:xfrm>
              <a:off x="5010484" y="1360000"/>
              <a:ext cx="3978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700" b="1" dirty="0" smtClean="0">
                  <a:latin typeface="Arial" pitchFamily="34" charset="0"/>
                  <a:cs typeface="Arial" pitchFamily="34" charset="0"/>
                  <a:sym typeface="Webdings"/>
                </a:rPr>
                <a:t>E2F4</a:t>
              </a:r>
            </a:p>
          </p:txBody>
        </p:sp>
        <p:sp>
          <p:nvSpPr>
            <p:cNvPr id="278" name="ZoneTexte 277"/>
            <p:cNvSpPr txBox="1"/>
            <p:nvPr/>
          </p:nvSpPr>
          <p:spPr>
            <a:xfrm>
              <a:off x="5114254" y="1179376"/>
              <a:ext cx="294096" cy="1478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700" b="1" dirty="0" smtClean="0">
                  <a:latin typeface="Arial" pitchFamily="34" charset="0"/>
                  <a:cs typeface="Arial" pitchFamily="34" charset="0"/>
                  <a:sym typeface="Webdings"/>
                </a:rPr>
                <a:t>E2F1</a:t>
              </a:r>
            </a:p>
          </p:txBody>
        </p:sp>
        <p:sp>
          <p:nvSpPr>
            <p:cNvPr id="279" name="ZoneTexte 278"/>
            <p:cNvSpPr txBox="1"/>
            <p:nvPr/>
          </p:nvSpPr>
          <p:spPr>
            <a:xfrm>
              <a:off x="4955982" y="1561012"/>
              <a:ext cx="45236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700" b="1" dirty="0" smtClean="0">
                  <a:latin typeface="Arial" pitchFamily="34" charset="0"/>
                  <a:cs typeface="Arial" pitchFamily="34" charset="0"/>
                  <a:sym typeface="Webdings"/>
                </a:rPr>
                <a:t>Hsp90</a:t>
              </a:r>
              <a:endParaRPr lang="fr-FR" sz="7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45" name="Picture 21" descr="C:\Users\Flo\Desktop\Thèse\Projet E2F1\Expériences\Blot\Blot 5-12-14 Cinetique 4j A375 Si E2F1 3 et 4\5-12-14-003.jpg"/>
            <p:cNvPicPr preferRelativeResize="0">
              <a:picLocks noChangeArrowheads="1"/>
            </p:cNvPicPr>
            <p:nvPr/>
          </p:nvPicPr>
          <p:blipFill>
            <a:blip r:embed="rId20" cstate="print"/>
            <a:srcRect l="59300" t="61310" r="30552" b="36620"/>
            <a:stretch>
              <a:fillRect/>
            </a:stretch>
          </p:blipFill>
          <p:spPr bwMode="auto">
            <a:xfrm>
              <a:off x="5371250" y="1384988"/>
              <a:ext cx="483450" cy="1415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</p:grpSp>
      <p:sp>
        <p:nvSpPr>
          <p:cNvPr id="162" name="Rectangle 161"/>
          <p:cNvSpPr/>
          <p:nvPr/>
        </p:nvSpPr>
        <p:spPr>
          <a:xfrm>
            <a:off x="3527791" y="3167942"/>
            <a:ext cx="366889" cy="1504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900"/>
          </a:p>
        </p:txBody>
      </p:sp>
      <p:sp>
        <p:nvSpPr>
          <p:cNvPr id="164" name="Rectangle 200"/>
          <p:cNvSpPr>
            <a:spLocks noChangeArrowheads="1"/>
          </p:cNvSpPr>
          <p:nvPr/>
        </p:nvSpPr>
        <p:spPr bwMode="auto">
          <a:xfrm rot="16233975">
            <a:off x="4876009" y="3791395"/>
            <a:ext cx="78098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Percent </a:t>
            </a:r>
            <a:r>
              <a:rPr lang="fr-FR" sz="600" b="1" dirty="0" err="1" smtClean="0">
                <a:latin typeface="Arial" pitchFamily="34" charset="0"/>
                <a:cs typeface="Arial" pitchFamily="34" charset="0"/>
              </a:rPr>
              <a:t>survival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Rectangle 200"/>
          <p:cNvSpPr>
            <a:spLocks noChangeArrowheads="1"/>
          </p:cNvSpPr>
          <p:nvPr/>
        </p:nvSpPr>
        <p:spPr bwMode="auto">
          <a:xfrm rot="16233975">
            <a:off x="3333217" y="3784468"/>
            <a:ext cx="90922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Relative expression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6" name="Picture 3" descr="C:\Users\Flo\Desktop\E2F4 2.jpg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5301107" y="3399245"/>
            <a:ext cx="1546942" cy="1047600"/>
          </a:xfrm>
          <a:prstGeom prst="rect">
            <a:avLst/>
          </a:prstGeom>
          <a:noFill/>
          <a:ln>
            <a:noFill/>
          </a:ln>
        </p:spPr>
      </p:pic>
      <p:sp>
        <p:nvSpPr>
          <p:cNvPr id="172" name="Rectangle 200"/>
          <p:cNvSpPr>
            <a:spLocks noChangeArrowheads="1"/>
          </p:cNvSpPr>
          <p:nvPr/>
        </p:nvSpPr>
        <p:spPr bwMode="auto">
          <a:xfrm>
            <a:off x="5436802" y="4101351"/>
            <a:ext cx="51809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600" b="1" dirty="0" smtClean="0">
                <a:latin typeface="Arial" pitchFamily="34" charset="0"/>
                <a:cs typeface="Arial" pitchFamily="34" charset="0"/>
              </a:rPr>
              <a:t>P=0.9858</a:t>
            </a:r>
            <a:endParaRPr lang="fr-FR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4" name="Picture 7" descr="C:\Users\Flo\Desktop\Expression Relative E2F4 2.jpg"/>
          <p:cNvPicPr>
            <a:picLocks noChangeAspect="1"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3830756" y="3392318"/>
            <a:ext cx="1406343" cy="1137600"/>
          </a:xfrm>
          <a:prstGeom prst="rect">
            <a:avLst/>
          </a:prstGeom>
          <a:noFill/>
        </p:spPr>
      </p:pic>
      <p:sp>
        <p:nvSpPr>
          <p:cNvPr id="187" name="ZoneTexte 186"/>
          <p:cNvSpPr txBox="1"/>
          <p:nvPr/>
        </p:nvSpPr>
        <p:spPr>
          <a:xfrm>
            <a:off x="5409011" y="3165626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  <a:sym typeface="Webdings"/>
              </a:rPr>
              <a:t>E2F4</a:t>
            </a:r>
          </a:p>
        </p:txBody>
      </p:sp>
      <p:sp>
        <p:nvSpPr>
          <p:cNvPr id="188" name="ZoneTexte 187"/>
          <p:cNvSpPr txBox="1"/>
          <p:nvPr/>
        </p:nvSpPr>
        <p:spPr>
          <a:xfrm>
            <a:off x="3583302" y="2781239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500" b="1" dirty="0" smtClean="0">
                <a:latin typeface="Arial" pitchFamily="34" charset="0"/>
                <a:cs typeface="Arial" pitchFamily="34" charset="0"/>
                <a:sym typeface="Webdings"/>
              </a:rPr>
              <a:t>E</a:t>
            </a:r>
          </a:p>
        </p:txBody>
      </p:sp>
      <p:sp>
        <p:nvSpPr>
          <p:cNvPr id="189" name="Rectangle 200"/>
          <p:cNvSpPr>
            <a:spLocks noChangeArrowheads="1"/>
          </p:cNvSpPr>
          <p:nvPr/>
        </p:nvSpPr>
        <p:spPr bwMode="auto">
          <a:xfrm>
            <a:off x="4290699" y="3227540"/>
            <a:ext cx="566181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700" b="1" dirty="0" smtClean="0">
                <a:latin typeface="Arial" pitchFamily="34" charset="0"/>
                <a:cs typeface="Arial" pitchFamily="34" charset="0"/>
              </a:rPr>
              <a:t>p&lt;0.0001</a:t>
            </a:r>
            <a:endParaRPr lang="fr-FR" sz="7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0" name="Groupe 189"/>
          <p:cNvGrpSpPr/>
          <p:nvPr/>
        </p:nvGrpSpPr>
        <p:grpSpPr>
          <a:xfrm>
            <a:off x="4271781" y="3408001"/>
            <a:ext cx="612000" cy="53298"/>
            <a:chOff x="5732249" y="4925102"/>
            <a:chExt cx="756000" cy="77961"/>
          </a:xfrm>
        </p:grpSpPr>
        <p:sp>
          <p:nvSpPr>
            <p:cNvPr id="191" name="Line 311"/>
            <p:cNvSpPr>
              <a:spLocks noChangeShapeType="1"/>
            </p:cNvSpPr>
            <p:nvPr/>
          </p:nvSpPr>
          <p:spPr bwMode="auto">
            <a:xfrm flipV="1">
              <a:off x="5732249" y="4928859"/>
              <a:ext cx="756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FR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2" name="Line 311"/>
            <p:cNvSpPr>
              <a:spLocks noChangeShapeType="1"/>
            </p:cNvSpPr>
            <p:nvPr/>
          </p:nvSpPr>
          <p:spPr bwMode="auto">
            <a:xfrm flipH="1">
              <a:off x="5732249" y="4925102"/>
              <a:ext cx="0" cy="779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FR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3" name="Line 311"/>
            <p:cNvSpPr>
              <a:spLocks noChangeShapeType="1"/>
            </p:cNvSpPr>
            <p:nvPr/>
          </p:nvSpPr>
          <p:spPr bwMode="auto">
            <a:xfrm flipH="1">
              <a:off x="6488249" y="4925102"/>
              <a:ext cx="0" cy="779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FR" sz="7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4" name="ZoneTexte 193"/>
          <p:cNvSpPr txBox="1"/>
          <p:nvPr/>
        </p:nvSpPr>
        <p:spPr>
          <a:xfrm>
            <a:off x="3844301" y="3158699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  <a:sym typeface="Webdings"/>
              </a:rPr>
              <a:t>E2F4</a:t>
            </a:r>
          </a:p>
        </p:txBody>
      </p:sp>
      <p:sp>
        <p:nvSpPr>
          <p:cNvPr id="171" name="Rectangle 200"/>
          <p:cNvSpPr>
            <a:spLocks noChangeArrowheads="1"/>
          </p:cNvSpPr>
          <p:nvPr/>
        </p:nvSpPr>
        <p:spPr bwMode="auto">
          <a:xfrm rot="16233975">
            <a:off x="-705500" y="3583160"/>
            <a:ext cx="175995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mRNA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expression </a:t>
            </a:r>
          </a:p>
          <a:p>
            <a:pPr algn="ct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fr-FR" sz="800" b="1" dirty="0" err="1" smtClean="0">
                <a:latin typeface="Arial" pitchFamily="34" charset="0"/>
                <a:cs typeface="Arial" pitchFamily="34" charset="0"/>
              </a:rPr>
              <a:t>Fold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 change)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55943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49</TotalTime>
  <Words>128</Words>
  <Application>Microsoft Office PowerPoint</Application>
  <PresentationFormat>Affichage à l'écran (4:3)</PresentationFormat>
  <Paragraphs>9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ian</dc:creator>
  <cp:lastModifiedBy>Steph</cp:lastModifiedBy>
  <cp:revision>207</cp:revision>
  <dcterms:created xsi:type="dcterms:W3CDTF">2016-06-21T13:54:45Z</dcterms:created>
  <dcterms:modified xsi:type="dcterms:W3CDTF">2018-03-11T12:55:42Z</dcterms:modified>
</cp:coreProperties>
</file>